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  <p:sldId id="280" r:id="rId3"/>
    <p:sldId id="281" r:id="rId4"/>
    <p:sldId id="282" r:id="rId5"/>
    <p:sldId id="283" r:id="rId6"/>
    <p:sldId id="279" r:id="rId7"/>
    <p:sldId id="278" r:id="rId8"/>
    <p:sldId id="269" r:id="rId9"/>
    <p:sldId id="270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9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E:\3%20Experimental%20data\Articles\JMT\BMC%20Genomics\Comparative%20content%20of%20flower%20fragranc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2007_Workbook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2007_Workbook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oeyee\Desktop\&#22270;&#29255;&#21450;&#25991;&#26723;&#20462;&#25913;\&#22270;&#29255;&#21450;&#25991;&#26723;&#20462;&#25913;\&#25152;&#26377;&#22522;&#22240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Sheet1!$B$1</c:f>
              <c:strCache>
                <c:ptCount val="1"/>
                <c:pt idx="0">
                  <c:v>Blooming stage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  <a:effectLst/>
          </c:spPr>
          <c:cat>
            <c:strRef>
              <c:f>Sheet1!$A$2:$A$4</c:f>
              <c:strCache>
                <c:ptCount val="3"/>
                <c:pt idx="0">
                  <c:v>Jasmonates</c:v>
                </c:pt>
                <c:pt idx="1">
                  <c:v>Alkanes</c:v>
                </c:pt>
                <c:pt idx="2">
                  <c:v>Dibutyl phthalate</c:v>
                </c:pt>
              </c:strCache>
            </c:strRef>
          </c:cat>
          <c:val>
            <c:numRef>
              <c:f>Sheet1!$B$2:$B$4</c:f>
              <c:numCache>
                <c:formatCode>0.00%</c:formatCode>
                <c:ptCount val="3"/>
                <c:pt idx="0">
                  <c:v>0.17870000000000003</c:v>
                </c:pt>
                <c:pt idx="1">
                  <c:v>0.10550000000000001</c:v>
                </c:pt>
                <c:pt idx="2">
                  <c:v>1.150000000000000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75F-459D-8D6B-8D8A32B95A54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Withered stag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cat>
            <c:strRef>
              <c:f>Sheet1!$A$2:$A$4</c:f>
              <c:strCache>
                <c:ptCount val="3"/>
                <c:pt idx="0">
                  <c:v>Jasmonates</c:v>
                </c:pt>
                <c:pt idx="1">
                  <c:v>Alkanes</c:v>
                </c:pt>
                <c:pt idx="2">
                  <c:v>Dibutyl phthalate</c:v>
                </c:pt>
              </c:strCache>
            </c:strRef>
          </c:cat>
          <c:val>
            <c:numRef>
              <c:f>Sheet1!$C$2:$C$4</c:f>
              <c:numCache>
                <c:formatCode>0.00%</c:formatCode>
                <c:ptCount val="3"/>
                <c:pt idx="0">
                  <c:v>1.0000000000000002E-4</c:v>
                </c:pt>
                <c:pt idx="1">
                  <c:v>1.0000000000000002E-4</c:v>
                </c:pt>
                <c:pt idx="2">
                  <c:v>1.0000000000000002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75F-459D-8D6B-8D8A32B95A54}"/>
            </c:ext>
          </c:extLst>
        </c:ser>
        <c:dLbls/>
        <c:gapWidth val="219"/>
        <c:overlap val="-27"/>
        <c:axId val="97411072"/>
        <c:axId val="97412608"/>
      </c:barChart>
      <c:catAx>
        <c:axId val="97411072"/>
        <c:scaling>
          <c:orientation val="minMax"/>
        </c:scaling>
        <c:axPos val="b"/>
        <c:numFmt formatCode="General" sourceLinked="1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412608"/>
        <c:crossesAt val="0"/>
        <c:lblAlgn val="ctr"/>
        <c:lblOffset val="100"/>
      </c:catAx>
      <c:valAx>
        <c:axId val="97412608"/>
        <c:scaling>
          <c:orientation val="minMax"/>
        </c:scaling>
        <c:axPos val="l"/>
        <c:numFmt formatCode="0%" sourceLinked="0"/>
        <c:maj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7411072"/>
        <c:crosses val="autoZero"/>
        <c:crossBetween val="between"/>
      </c:valAx>
      <c:spPr>
        <a:solidFill>
          <a:sysClr val="window" lastClr="FFFFFF"/>
        </a:solidFill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layout>
        <c:manualLayout>
          <c:xMode val="edge"/>
          <c:yMode val="edge"/>
          <c:x val="0.76424300087489172"/>
          <c:y val="0.2593456150861812"/>
        </c:manualLayout>
      </c:layout>
    </c:title>
    <c:plotArea>
      <c:layout>
        <c:manualLayout>
          <c:layoutTarget val="inner"/>
          <c:xMode val="edge"/>
          <c:yMode val="edge"/>
          <c:x val="0.1159659886264217"/>
          <c:y val="0.10742982039805632"/>
          <c:w val="0.50800196850393697"/>
          <c:h val="0.76498886895470963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E-value</c:v>
                </c:pt>
              </c:strCache>
            </c:strRef>
          </c:tx>
          <c:dLbls>
            <c:spPr>
              <a:noFill/>
              <a:ln>
                <a:noFill/>
              </a:ln>
              <a:effectLst/>
            </c:spPr>
            <c:showVal val="1"/>
            <c:showLeaderLines val="1"/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Sheet1!$A$2:$A$6</c:f>
              <c:strCache>
                <c:ptCount val="5"/>
                <c:pt idx="0">
                  <c:v>0~1e-150</c:v>
                </c:pt>
                <c:pt idx="1">
                  <c:v>1e-150~1e-100</c:v>
                </c:pt>
                <c:pt idx="2">
                  <c:v>1e-100~1e-50</c:v>
                </c:pt>
                <c:pt idx="3">
                  <c:v>1e-50~1e-20</c:v>
                </c:pt>
                <c:pt idx="4">
                  <c:v>1e-20~1e-5</c:v>
                </c:pt>
              </c:strCache>
            </c:strRef>
          </c:cat>
          <c:val>
            <c:numRef>
              <c:f>Sheet1!$B$2:$B$6</c:f>
              <c:numCache>
                <c:formatCode>0.00%</c:formatCode>
                <c:ptCount val="5"/>
                <c:pt idx="0">
                  <c:v>0.18440000000000029</c:v>
                </c:pt>
                <c:pt idx="1">
                  <c:v>0.1179</c:v>
                </c:pt>
                <c:pt idx="2">
                  <c:v>0.2046</c:v>
                </c:pt>
                <c:pt idx="3">
                  <c:v>0.2676</c:v>
                </c:pt>
                <c:pt idx="4">
                  <c:v>0.2255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57D-4FCE-8EC1-BE45329480F0}"/>
            </c:ext>
          </c:extLst>
        </c:ser>
        <c:dLbls/>
        <c:firstSliceAng val="0"/>
      </c:pieChart>
    </c:plotArea>
    <c:legend>
      <c:legendPos val="r"/>
      <c:layout>
        <c:manualLayout>
          <c:xMode val="edge"/>
          <c:yMode val="edge"/>
          <c:x val="0.67882294400699961"/>
          <c:y val="0.36650419962695657"/>
          <c:w val="0.28923261154855645"/>
          <c:h val="0.28448705462232343"/>
        </c:manualLayout>
      </c:layout>
    </c:legend>
    <c:plotVisOnly val="1"/>
    <c:dispBlanksAs val="zero"/>
  </c:chart>
  <c:txPr>
    <a:bodyPr/>
    <a:lstStyle/>
    <a:p>
      <a:pPr>
        <a:defRPr sz="1800"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1.7782476242547789E-2"/>
          <c:y val="0.10756681695326474"/>
          <c:w val="0.55462267216021688"/>
          <c:h val="0.75862474541767999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pecies</c:v>
                </c:pt>
              </c:strCache>
            </c:strRef>
          </c:tx>
          <c:dLbls>
            <c:spPr>
              <a:noFill/>
              <a:ln>
                <a:noFill/>
              </a:ln>
              <a:effectLst/>
            </c:spPr>
            <c:showVal val="1"/>
            <c:showLeaderLines val="1"/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Sheet1!$A$2:$A$10</c:f>
              <c:strCache>
                <c:ptCount val="9"/>
                <c:pt idx="0">
                  <c:v>Phoenix dactylifera </c:v>
                </c:pt>
                <c:pt idx="1">
                  <c:v>Musa acuminata subsp malaccensis </c:v>
                </c:pt>
                <c:pt idx="2">
                  <c:v>Vitis vinifera</c:v>
                </c:pt>
                <c:pt idx="3">
                  <c:v>Nelumbo nucifera</c:v>
                </c:pt>
                <c:pt idx="4">
                  <c:v>Oryza sativa japonica group</c:v>
                </c:pt>
                <c:pt idx="5">
                  <c:v>Theobroma cacao</c:v>
                </c:pt>
                <c:pt idx="6">
                  <c:v>Glycine max</c:v>
                </c:pt>
                <c:pt idx="7">
                  <c:v>Arabidopsis thaliana</c:v>
                </c:pt>
                <c:pt idx="8">
                  <c:v>other species</c:v>
                </c:pt>
              </c:strCache>
            </c:strRef>
          </c:cat>
          <c:val>
            <c:numRef>
              <c:f>Sheet1!$B$2:$B$10</c:f>
              <c:numCache>
                <c:formatCode>0.00%</c:formatCode>
                <c:ptCount val="9"/>
                <c:pt idx="0">
                  <c:v>0.41120000000000001</c:v>
                </c:pt>
                <c:pt idx="1">
                  <c:v>0.14620000000000022</c:v>
                </c:pt>
                <c:pt idx="2">
                  <c:v>4.2800000000000032E-2</c:v>
                </c:pt>
                <c:pt idx="3">
                  <c:v>3.6999999999999998E-2</c:v>
                </c:pt>
                <c:pt idx="4">
                  <c:v>1.7800000000000003E-2</c:v>
                </c:pt>
                <c:pt idx="5">
                  <c:v>1.2900000000000003E-2</c:v>
                </c:pt>
                <c:pt idx="6">
                  <c:v>1.0300000000000005E-2</c:v>
                </c:pt>
                <c:pt idx="7">
                  <c:v>9.4000000000000142E-3</c:v>
                </c:pt>
                <c:pt idx="8">
                  <c:v>0.312400000000000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228-4129-ADA8-D3F5D16E2510}"/>
            </c:ext>
          </c:extLst>
        </c:ser>
        <c:dLbls/>
        <c:firstSliceAng val="270"/>
      </c:pieChart>
    </c:plotArea>
    <c:legend>
      <c:legendPos val="r"/>
      <c:layout>
        <c:manualLayout>
          <c:xMode val="edge"/>
          <c:yMode val="edge"/>
          <c:x val="0.61341514684767451"/>
          <c:y val="0.11918815325006286"/>
          <c:w val="0.37762133045496832"/>
          <c:h val="0.82150163103238261"/>
        </c:manualLayout>
      </c:layout>
      <c:txPr>
        <a:bodyPr/>
        <a:lstStyle/>
        <a:p>
          <a:pPr>
            <a:defRPr sz="1600" kern="800" baseline="0"/>
          </a:pPr>
          <a:endParaRPr lang="en-US"/>
        </a:p>
      </c:txPr>
    </c:legend>
    <c:plotVisOnly val="1"/>
    <c:dispBlanksAs val="zero"/>
  </c:chart>
  <c:txPr>
    <a:bodyPr/>
    <a:lstStyle/>
    <a:p>
      <a:pPr>
        <a:defRPr sz="1800"/>
      </a:pPr>
      <a:endParaRPr lang="en-US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pieChart>
        <c:varyColors val="1"/>
        <c:ser>
          <c:idx val="0"/>
          <c:order val="0"/>
          <c:dPt>
            <c:idx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0-DE42-48C2-9F5F-B62B470CD220}"/>
              </c:ext>
            </c:extLst>
          </c:dPt>
          <c:dPt>
            <c:idx val="1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E42-48C2-9F5F-B62B470CD220}"/>
              </c:ext>
            </c:extLst>
          </c:dPt>
          <c:dPt>
            <c:idx val="2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DE42-48C2-9F5F-B62B470CD220}"/>
              </c:ext>
            </c:extLst>
          </c:dPt>
          <c:dPt>
            <c:idx val="3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E42-48C2-9F5F-B62B470CD220}"/>
              </c:ext>
            </c:extLst>
          </c:dPt>
          <c:dPt>
            <c:idx val="4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DE42-48C2-9F5F-B62B470CD220}"/>
              </c:ext>
            </c:extLst>
          </c:dPt>
          <c:dPt>
            <c:idx val="5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E42-48C2-9F5F-B62B470CD220}"/>
              </c:ext>
            </c:extLst>
          </c:dPt>
          <c:dPt>
            <c:idx val="6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6-DE42-48C2-9F5F-B62B470CD220}"/>
              </c:ext>
            </c:extLst>
          </c:dPt>
          <c:dPt>
            <c:idx val="7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DE42-48C2-9F5F-B62B470CD220}"/>
              </c:ext>
            </c:extLst>
          </c:dPt>
          <c:dPt>
            <c:idx val="8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8-DE42-48C2-9F5F-B62B470CD220}"/>
              </c:ext>
            </c:extLst>
          </c:dPt>
          <c:dPt>
            <c:idx val="9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DE42-48C2-9F5F-B62B470CD220}"/>
              </c:ext>
            </c:extLst>
          </c:dPt>
          <c:dPt>
            <c:idx val="1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A-DE42-48C2-9F5F-B62B470CD220}"/>
              </c:ext>
            </c:extLst>
          </c:dPt>
          <c:dPt>
            <c:idx val="11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DE42-48C2-9F5F-B62B470CD220}"/>
              </c:ext>
            </c:extLst>
          </c:dPt>
          <c:dPt>
            <c:idx val="12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DE42-48C2-9F5F-B62B470CD220}"/>
              </c:ext>
            </c:extLst>
          </c:dPt>
          <c:dPt>
            <c:idx val="13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DE42-48C2-9F5F-B62B470CD220}"/>
              </c:ext>
            </c:extLst>
          </c:dPt>
          <c:dPt>
            <c:idx val="14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DE42-48C2-9F5F-B62B470CD220}"/>
              </c:ext>
            </c:extLst>
          </c:dPt>
          <c:dPt>
            <c:idx val="15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DE42-48C2-9F5F-B62B470CD220}"/>
              </c:ext>
            </c:extLst>
          </c:dPt>
          <c:dPt>
            <c:idx val="16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0-DE42-48C2-9F5F-B62B470CD220}"/>
              </c:ext>
            </c:extLst>
          </c:dPt>
          <c:dPt>
            <c:idx val="17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DE42-48C2-9F5F-B62B470CD220}"/>
              </c:ext>
            </c:extLst>
          </c:dPt>
          <c:dPt>
            <c:idx val="18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2-DE42-48C2-9F5F-B62B470CD220}"/>
              </c:ext>
            </c:extLst>
          </c:dPt>
          <c:dPt>
            <c:idx val="19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DE42-48C2-9F5F-B62B470CD220}"/>
              </c:ext>
            </c:extLst>
          </c:dPt>
          <c:dPt>
            <c:idx val="2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4-DE42-48C2-9F5F-B62B470CD220}"/>
              </c:ext>
            </c:extLst>
          </c:dPt>
          <c:dPt>
            <c:idx val="21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DE42-48C2-9F5F-B62B470CD220}"/>
              </c:ext>
            </c:extLst>
          </c:dPt>
          <c:dPt>
            <c:idx val="22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6-DE42-48C2-9F5F-B62B470CD220}"/>
              </c:ext>
            </c:extLst>
          </c:dPt>
          <c:dPt>
            <c:idx val="23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DE42-48C2-9F5F-B62B470CD220}"/>
              </c:ext>
            </c:extLst>
          </c:dPt>
          <c:dPt>
            <c:idx val="24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8-DE42-48C2-9F5F-B62B470CD220}"/>
              </c:ext>
            </c:extLst>
          </c:dPt>
          <c:dPt>
            <c:idx val="25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9-DE42-48C2-9F5F-B62B470CD220}"/>
              </c:ext>
            </c:extLst>
          </c:dPt>
          <c:dPt>
            <c:idx val="26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A-DE42-48C2-9F5F-B62B470CD220}"/>
              </c:ext>
            </c:extLst>
          </c:dPt>
          <c:dPt>
            <c:idx val="27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B-DE42-48C2-9F5F-B62B470CD220}"/>
              </c:ext>
            </c:extLst>
          </c:dPt>
          <c:dPt>
            <c:idx val="28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C-DE42-48C2-9F5F-B62B470CD220}"/>
              </c:ext>
            </c:extLst>
          </c:dPt>
          <c:dPt>
            <c:idx val="29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D-DE42-48C2-9F5F-B62B470CD220}"/>
              </c:ext>
            </c:extLst>
          </c:dPt>
          <c:dPt>
            <c:idx val="3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E-DE42-48C2-9F5F-B62B470CD220}"/>
              </c:ext>
            </c:extLst>
          </c:dPt>
          <c:dPt>
            <c:idx val="31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F-DE42-48C2-9F5F-B62B470CD220}"/>
              </c:ext>
            </c:extLst>
          </c:dPt>
          <c:dPt>
            <c:idx val="32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0-DE42-48C2-9F5F-B62B470CD220}"/>
              </c:ext>
            </c:extLst>
          </c:dPt>
          <c:dPt>
            <c:idx val="33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1-DE42-48C2-9F5F-B62B470CD220}"/>
              </c:ext>
            </c:extLst>
          </c:dPt>
          <c:dPt>
            <c:idx val="34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2-DE42-48C2-9F5F-B62B470CD220}"/>
              </c:ext>
            </c:extLst>
          </c:dPt>
          <c:dPt>
            <c:idx val="35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3-DE42-48C2-9F5F-B62B470CD220}"/>
              </c:ext>
            </c:extLst>
          </c:dPt>
          <c:dPt>
            <c:idx val="36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4-DE42-48C2-9F5F-B62B470CD220}"/>
              </c:ext>
            </c:extLst>
          </c:dPt>
          <c:dPt>
            <c:idx val="37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5-DE42-48C2-9F5F-B62B470CD220}"/>
              </c:ext>
            </c:extLst>
          </c:dPt>
          <c:dPt>
            <c:idx val="38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6-DE42-48C2-9F5F-B62B470CD220}"/>
              </c:ext>
            </c:extLst>
          </c:dPt>
          <c:dPt>
            <c:idx val="39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7-DE42-48C2-9F5F-B62B470CD220}"/>
              </c:ext>
            </c:extLst>
          </c:dPt>
          <c:dPt>
            <c:idx val="4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8-DE42-48C2-9F5F-B62B470CD220}"/>
              </c:ext>
            </c:extLst>
          </c:dPt>
          <c:dPt>
            <c:idx val="41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9-DE42-48C2-9F5F-B62B470CD220}"/>
              </c:ext>
            </c:extLst>
          </c:dPt>
          <c:dPt>
            <c:idx val="42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2A-DE42-48C2-9F5F-B62B470CD220}"/>
              </c:ext>
            </c:extLst>
          </c:dPt>
          <c:dLbls>
            <c:dLbl>
              <c:idx val="18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Val val="1"/>
            <c:showCatName val="1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/>
            </c:extLst>
          </c:dLbls>
          <c:cat>
            <c:strRef>
              <c:f>genes.TMM.fpkm.matrix!$A$2:$A$44</c:f>
              <c:strCache>
                <c:ptCount val="43"/>
                <c:pt idx="0">
                  <c:v>TAZ</c:v>
                </c:pt>
                <c:pt idx="1">
                  <c:v>NAC</c:v>
                </c:pt>
                <c:pt idx="2">
                  <c:v>TCP</c:v>
                </c:pt>
                <c:pt idx="3">
                  <c:v>LFY</c:v>
                </c:pt>
                <c:pt idx="4">
                  <c:v>LIM</c:v>
                </c:pt>
                <c:pt idx="5">
                  <c:v>WRKY</c:v>
                </c:pt>
                <c:pt idx="6">
                  <c:v>GRF</c:v>
                </c:pt>
                <c:pt idx="7">
                  <c:v>zf-HD</c:v>
                </c:pt>
                <c:pt idx="8">
                  <c:v>PLATZ</c:v>
                </c:pt>
                <c:pt idx="9">
                  <c:v>TIG</c:v>
                </c:pt>
                <c:pt idx="10">
                  <c:v>FHA</c:v>
                </c:pt>
                <c:pt idx="11">
                  <c:v>MADS</c:v>
                </c:pt>
                <c:pt idx="12">
                  <c:v>MYB</c:v>
                </c:pt>
                <c:pt idx="13">
                  <c:v>BSD</c:v>
                </c:pt>
                <c:pt idx="14">
                  <c:v>LOB</c:v>
                </c:pt>
                <c:pt idx="15">
                  <c:v>bHLH</c:v>
                </c:pt>
                <c:pt idx="16">
                  <c:v>PBF-2-like</c:v>
                </c:pt>
                <c:pt idx="17">
                  <c:v>GRAS</c:v>
                </c:pt>
                <c:pt idx="18">
                  <c:v>C2C2-CO-like</c:v>
                </c:pt>
                <c:pt idx="19">
                  <c:v>GeBP</c:v>
                </c:pt>
                <c:pt idx="20">
                  <c:v>ABI3VP1</c:v>
                </c:pt>
                <c:pt idx="21">
                  <c:v>E2F-DP</c:v>
                </c:pt>
                <c:pt idx="22">
                  <c:v>C2H2</c:v>
                </c:pt>
                <c:pt idx="23">
                  <c:v>S1Fa-like</c:v>
                </c:pt>
                <c:pt idx="24">
                  <c:v>EIL</c:v>
                </c:pt>
                <c:pt idx="25">
                  <c:v>mTERF</c:v>
                </c:pt>
                <c:pt idx="26">
                  <c:v>FAR1</c:v>
                </c:pt>
                <c:pt idx="27">
                  <c:v>HB</c:v>
                </c:pt>
                <c:pt idx="28">
                  <c:v>CSD</c:v>
                </c:pt>
                <c:pt idx="29">
                  <c:v>Sigma70-like</c:v>
                </c:pt>
                <c:pt idx="30">
                  <c:v>RWP-RK</c:v>
                </c:pt>
                <c:pt idx="31">
                  <c:v>C2C2-YABBY</c:v>
                </c:pt>
                <c:pt idx="32">
                  <c:v>TUB</c:v>
                </c:pt>
                <c:pt idx="33">
                  <c:v>ARF</c:v>
                </c:pt>
                <c:pt idx="34">
                  <c:v>SBP</c:v>
                </c:pt>
                <c:pt idx="35">
                  <c:v>C2C2-GATA</c:v>
                </c:pt>
                <c:pt idx="36">
                  <c:v>C3H</c:v>
                </c:pt>
                <c:pt idx="37">
                  <c:v>AP2-EREBP</c:v>
                </c:pt>
                <c:pt idx="38">
                  <c:v>HSF</c:v>
                </c:pt>
                <c:pt idx="39">
                  <c:v>SRS</c:v>
                </c:pt>
                <c:pt idx="40">
                  <c:v>bZIP</c:v>
                </c:pt>
                <c:pt idx="41">
                  <c:v>Tify</c:v>
                </c:pt>
                <c:pt idx="42">
                  <c:v>C2C2-Dof</c:v>
                </c:pt>
              </c:strCache>
            </c:strRef>
          </c:cat>
          <c:val>
            <c:numRef>
              <c:f>genes.TMM.fpkm.matrix!$B$2:$B$44</c:f>
              <c:numCache>
                <c:formatCode>General</c:formatCode>
                <c:ptCount val="43"/>
                <c:pt idx="0">
                  <c:v>3</c:v>
                </c:pt>
                <c:pt idx="1">
                  <c:v>52</c:v>
                </c:pt>
                <c:pt idx="2">
                  <c:v>18</c:v>
                </c:pt>
                <c:pt idx="3">
                  <c:v>3</c:v>
                </c:pt>
                <c:pt idx="4">
                  <c:v>7</c:v>
                </c:pt>
                <c:pt idx="5">
                  <c:v>41</c:v>
                </c:pt>
                <c:pt idx="6">
                  <c:v>5</c:v>
                </c:pt>
                <c:pt idx="7">
                  <c:v>10</c:v>
                </c:pt>
                <c:pt idx="8">
                  <c:v>5</c:v>
                </c:pt>
                <c:pt idx="9">
                  <c:v>5</c:v>
                </c:pt>
                <c:pt idx="10">
                  <c:v>15</c:v>
                </c:pt>
                <c:pt idx="11">
                  <c:v>32</c:v>
                </c:pt>
                <c:pt idx="12">
                  <c:v>129</c:v>
                </c:pt>
                <c:pt idx="13">
                  <c:v>6</c:v>
                </c:pt>
                <c:pt idx="14">
                  <c:v>13</c:v>
                </c:pt>
                <c:pt idx="15">
                  <c:v>72</c:v>
                </c:pt>
                <c:pt idx="16">
                  <c:v>1</c:v>
                </c:pt>
                <c:pt idx="17">
                  <c:v>48</c:v>
                </c:pt>
                <c:pt idx="18">
                  <c:v>6</c:v>
                </c:pt>
                <c:pt idx="19">
                  <c:v>10</c:v>
                </c:pt>
                <c:pt idx="20">
                  <c:v>25</c:v>
                </c:pt>
                <c:pt idx="21">
                  <c:v>5</c:v>
                </c:pt>
                <c:pt idx="22">
                  <c:v>49</c:v>
                </c:pt>
                <c:pt idx="23">
                  <c:v>2</c:v>
                </c:pt>
                <c:pt idx="24">
                  <c:v>4</c:v>
                </c:pt>
                <c:pt idx="25">
                  <c:v>28</c:v>
                </c:pt>
                <c:pt idx="26">
                  <c:v>32</c:v>
                </c:pt>
                <c:pt idx="27">
                  <c:v>2</c:v>
                </c:pt>
                <c:pt idx="28">
                  <c:v>7</c:v>
                </c:pt>
                <c:pt idx="29">
                  <c:v>3</c:v>
                </c:pt>
                <c:pt idx="30">
                  <c:v>4</c:v>
                </c:pt>
                <c:pt idx="31">
                  <c:v>10</c:v>
                </c:pt>
                <c:pt idx="32">
                  <c:v>12</c:v>
                </c:pt>
                <c:pt idx="33">
                  <c:v>18</c:v>
                </c:pt>
                <c:pt idx="34">
                  <c:v>13</c:v>
                </c:pt>
                <c:pt idx="35">
                  <c:v>14</c:v>
                </c:pt>
                <c:pt idx="36">
                  <c:v>53</c:v>
                </c:pt>
                <c:pt idx="37">
                  <c:v>87</c:v>
                </c:pt>
                <c:pt idx="38">
                  <c:v>18</c:v>
                </c:pt>
                <c:pt idx="39">
                  <c:v>2</c:v>
                </c:pt>
                <c:pt idx="40">
                  <c:v>25</c:v>
                </c:pt>
                <c:pt idx="41">
                  <c:v>15</c:v>
                </c:pt>
                <c:pt idx="42">
                  <c:v>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2B-DE42-48C2-9F5F-B62B470CD220}"/>
            </c:ext>
          </c:extLst>
        </c:ser>
        <c:dLbls/>
        <c:firstSliceAng val="0"/>
      </c:pieChart>
      <c:spPr>
        <a:noFill/>
        <a:ln w="25400">
          <a:noFill/>
        </a:ln>
      </c:spPr>
    </c:plotArea>
    <c:plotVisOnly val="1"/>
    <c:dispBlanksAs val="zero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内容占位符 2">
            <a:extLst>
              <a:ext uri="{FF2B5EF4-FFF2-40B4-BE49-F238E27FC236}">
                <a16:creationId xmlns:a16="http://schemas.microsoft.com/office/drawing/2014/main" xmlns="" id="{ECBCC87C-3031-4C0A-AD72-C507C0EE5CE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3357554" cy="4714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342900" lvl="0" indent="-342900">
              <a:spcBef>
                <a:spcPct val="20000"/>
              </a:spcBef>
              <a:defRPr/>
            </a:pPr>
            <a:r>
              <a:rPr lang="en-US" altLang="zh-CN" dirty="0" smtClean="0"/>
              <a:t>Figure S1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xmlns="" id="{2DD7075D-6F61-4051-99F9-C7B2DE25F6F0}"/>
              </a:ext>
            </a:extLst>
          </p:cNvPr>
          <p:cNvGrpSpPr/>
          <p:nvPr/>
        </p:nvGrpSpPr>
        <p:grpSpPr>
          <a:xfrm>
            <a:off x="1342672" y="1556792"/>
            <a:ext cx="5515328" cy="3243808"/>
            <a:chOff x="1342672" y="1556792"/>
            <a:chExt cx="5515328" cy="3243808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xmlns="" id="{B53CDCBF-A1AF-4CAB-8CA4-D8362923FD79}"/>
                </a:ext>
              </a:extLst>
            </p:cNvPr>
            <p:cNvGrpSpPr/>
            <p:nvPr/>
          </p:nvGrpSpPr>
          <p:grpSpPr>
            <a:xfrm>
              <a:off x="1619672" y="1628800"/>
              <a:ext cx="5238328" cy="3171800"/>
              <a:chOff x="1619672" y="1628800"/>
              <a:chExt cx="5238328" cy="3171800"/>
            </a:xfrm>
          </p:grpSpPr>
          <p:graphicFrame>
            <p:nvGraphicFramePr>
              <p:cNvPr id="6" name="图表 5">
                <a:extLst>
                  <a:ext uri="{FF2B5EF4-FFF2-40B4-BE49-F238E27FC236}">
                    <a16:creationId xmlns:a16="http://schemas.microsoft.com/office/drawing/2014/main" xmlns="" id="{1540C645-1496-4B26-B0F9-5302EF516EC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xmlns="" val="3518340699"/>
                  </p:ext>
                </p:extLst>
              </p:nvPr>
            </p:nvGraphicFramePr>
            <p:xfrm>
              <a:off x="1619672" y="1628800"/>
              <a:ext cx="5238328" cy="3171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7" name="矩形 6">
                <a:extLst>
                  <a:ext uri="{FF2B5EF4-FFF2-40B4-BE49-F238E27FC236}">
                    <a16:creationId xmlns:a16="http://schemas.microsoft.com/office/drawing/2014/main" xmlns="" id="{9E974A07-1ABB-4279-9B89-5A259EBF7CE6}"/>
                  </a:ext>
                </a:extLst>
              </p:cNvPr>
              <p:cNvSpPr/>
              <p:nvPr/>
            </p:nvSpPr>
            <p:spPr>
              <a:xfrm>
                <a:off x="4932040" y="1916832"/>
                <a:ext cx="432048" cy="144016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xmlns="" id="{EA6BD858-0B2A-4820-AF7F-B43288A2D444}"/>
                  </a:ext>
                </a:extLst>
              </p:cNvPr>
              <p:cNvSpPr txBox="1"/>
              <p:nvPr/>
            </p:nvSpPr>
            <p:spPr>
              <a:xfrm>
                <a:off x="5310691" y="1871246"/>
                <a:ext cx="10615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/>
                  <a:t>Blooming stage</a:t>
                </a:r>
                <a:endParaRPr lang="zh-CN" altLang="en-US" sz="1100" dirty="0"/>
              </a:p>
            </p:txBody>
          </p:sp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xmlns="" id="{7F6DA277-D894-4D83-8BFB-AE51F5D6CF38}"/>
                  </a:ext>
                </a:extLst>
              </p:cNvPr>
              <p:cNvSpPr/>
              <p:nvPr/>
            </p:nvSpPr>
            <p:spPr>
              <a:xfrm>
                <a:off x="4932040" y="2132856"/>
                <a:ext cx="432048" cy="144016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xmlns="" id="{FADC087B-22B0-4686-991F-1A179370FA98}"/>
                  </a:ext>
                </a:extLst>
              </p:cNvPr>
              <p:cNvSpPr txBox="1"/>
              <p:nvPr/>
            </p:nvSpPr>
            <p:spPr>
              <a:xfrm>
                <a:off x="5310691" y="2087270"/>
                <a:ext cx="10631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/>
                  <a:t>Withered stage</a:t>
                </a:r>
                <a:endParaRPr lang="zh-CN" altLang="en-US" sz="1100" dirty="0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xmlns="" id="{D4DADC64-E473-4953-9FDC-A6C58037E707}"/>
                  </a:ext>
                </a:extLst>
              </p:cNvPr>
              <p:cNvSpPr txBox="1"/>
              <p:nvPr/>
            </p:nvSpPr>
            <p:spPr>
              <a:xfrm>
                <a:off x="5860776" y="4293096"/>
                <a:ext cx="3674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/>
                  <a:t>n.d</a:t>
                </a:r>
                <a:endParaRPr lang="zh-CN" altLang="en-US" sz="1100" dirty="0"/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xmlns="" id="{7E23CFC9-CF9A-42FE-AA52-4437E0747703}"/>
                  </a:ext>
                </a:extLst>
              </p:cNvPr>
              <p:cNvSpPr txBox="1"/>
              <p:nvPr/>
            </p:nvSpPr>
            <p:spPr>
              <a:xfrm>
                <a:off x="4283968" y="4293096"/>
                <a:ext cx="3674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/>
                  <a:t>n.d</a:t>
                </a:r>
                <a:endParaRPr lang="zh-CN" altLang="en-US" sz="1100" dirty="0"/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xmlns="" id="{8EAB322D-C469-4180-A8DD-8A9F073CC364}"/>
                  </a:ext>
                </a:extLst>
              </p:cNvPr>
              <p:cNvSpPr txBox="1"/>
              <p:nvPr/>
            </p:nvSpPr>
            <p:spPr>
              <a:xfrm>
                <a:off x="2699792" y="4293096"/>
                <a:ext cx="3674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/>
                  <a:t>n.d</a:t>
                </a:r>
                <a:endParaRPr lang="zh-CN" altLang="en-US" sz="1100" dirty="0"/>
              </a:p>
            </p:txBody>
          </p:sp>
        </p:grp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xmlns="" id="{051E1DCB-716E-4872-ABD7-90FE71129D1B}"/>
                </a:ext>
              </a:extLst>
            </p:cNvPr>
            <p:cNvSpPr txBox="1"/>
            <p:nvPr/>
          </p:nvSpPr>
          <p:spPr>
            <a:xfrm rot="16200000">
              <a:off x="41012" y="2858452"/>
              <a:ext cx="28803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The relative content of main components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xmlns="" val="32861370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内容占位符 2"/>
          <p:cNvSpPr txBox="1">
            <a:spLocks/>
          </p:cNvSpPr>
          <p:nvPr/>
        </p:nvSpPr>
        <p:spPr>
          <a:xfrm>
            <a:off x="0" y="0"/>
            <a:ext cx="2857488" cy="5000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 algn="ctr">
              <a:spcBef>
                <a:spcPct val="20000"/>
              </a:spcBef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Figure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lang="en-US" altLang="zh-CN" dirty="0" smtClean="0"/>
              <a:t>S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graphicFrame>
        <p:nvGraphicFramePr>
          <p:cNvPr id="5" name="图表 4"/>
          <p:cNvGraphicFramePr/>
          <p:nvPr/>
        </p:nvGraphicFramePr>
        <p:xfrm>
          <a:off x="0" y="785794"/>
          <a:ext cx="9144000" cy="6072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图表 6"/>
          <p:cNvGraphicFramePr/>
          <p:nvPr/>
        </p:nvGraphicFramePr>
        <p:xfrm>
          <a:off x="357158" y="420914"/>
          <a:ext cx="8501122" cy="61513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内容占位符 2"/>
          <p:cNvSpPr txBox="1">
            <a:spLocks/>
          </p:cNvSpPr>
          <p:nvPr/>
        </p:nvSpPr>
        <p:spPr>
          <a:xfrm>
            <a:off x="0" y="0"/>
            <a:ext cx="2857488" cy="5000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 algn="ctr">
              <a:spcBef>
                <a:spcPct val="20000"/>
              </a:spcBef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Figure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lang="en-US" altLang="zh-CN" dirty="0" smtClean="0"/>
              <a:t>S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3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内容占位符 2"/>
          <p:cNvSpPr txBox="1">
            <a:spLocks/>
          </p:cNvSpPr>
          <p:nvPr/>
        </p:nvSpPr>
        <p:spPr>
          <a:xfrm>
            <a:off x="0" y="0"/>
            <a:ext cx="2857488" cy="5000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 algn="ctr">
              <a:spcBef>
                <a:spcPct val="20000"/>
              </a:spcBef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Figure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lang="en-US" altLang="zh-CN" dirty="0" smtClean="0"/>
              <a:t>S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4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graphicFrame>
        <p:nvGraphicFramePr>
          <p:cNvPr id="4" name="图表 3"/>
          <p:cNvGraphicFramePr>
            <a:graphicFrameLocks/>
          </p:cNvGraphicFramePr>
          <p:nvPr/>
        </p:nvGraphicFramePr>
        <p:xfrm>
          <a:off x="214312" y="447675"/>
          <a:ext cx="8715375" cy="5962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7"/>
          <p:cNvGrpSpPr/>
          <p:nvPr/>
        </p:nvGrpSpPr>
        <p:grpSpPr>
          <a:xfrm>
            <a:off x="4000496" y="1142984"/>
            <a:ext cx="1522126" cy="5000660"/>
            <a:chOff x="4000496" y="1142984"/>
            <a:chExt cx="1522126" cy="5000660"/>
          </a:xfrm>
        </p:grpSpPr>
        <p:pic>
          <p:nvPicPr>
            <p:cNvPr id="5" name="图片 4" descr="图片1.jpg"/>
            <p:cNvPicPr>
              <a:picLocks noChangeAspect="1"/>
            </p:cNvPicPr>
            <p:nvPr/>
          </p:nvPicPr>
          <p:blipFill>
            <a:blip r:embed="rId2" cstate="print">
              <a:lum bright="-10000"/>
            </a:blip>
            <a:srcRect l="12649" t="3290" r="21987" b="6037"/>
            <a:stretch>
              <a:fillRect/>
            </a:stretch>
          </p:blipFill>
          <p:spPr>
            <a:xfrm>
              <a:off x="4000496" y="1428736"/>
              <a:ext cx="1000132" cy="471490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4143372" y="1142984"/>
              <a:ext cx="13253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     M     kb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929190" y="2867777"/>
              <a:ext cx="593432" cy="24186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5</a:t>
              </a:r>
            </a:p>
            <a:p>
              <a:r>
                <a:rPr lang="en-US" altLang="zh-CN" dirty="0"/>
                <a:t>3</a:t>
              </a:r>
            </a:p>
            <a:p>
              <a:r>
                <a:rPr lang="en-US" altLang="zh-CN" dirty="0"/>
                <a:t>2</a:t>
              </a:r>
            </a:p>
            <a:p>
              <a:r>
                <a:rPr lang="en-US" altLang="zh-CN" dirty="0"/>
                <a:t>1.5</a:t>
              </a:r>
            </a:p>
            <a:p>
              <a:pPr>
                <a:lnSpc>
                  <a:spcPts val="1800"/>
                </a:lnSpc>
              </a:pPr>
              <a:r>
                <a:rPr lang="en-US" altLang="zh-CN" dirty="0"/>
                <a:t>1</a:t>
              </a:r>
            </a:p>
            <a:p>
              <a:pPr>
                <a:lnSpc>
                  <a:spcPts val="1800"/>
                </a:lnSpc>
              </a:pPr>
              <a:r>
                <a:rPr lang="en-US" altLang="zh-CN" dirty="0"/>
                <a:t>0.75</a:t>
              </a:r>
            </a:p>
            <a:p>
              <a:pPr>
                <a:lnSpc>
                  <a:spcPts val="1800"/>
                </a:lnSpc>
              </a:pPr>
              <a:r>
                <a:rPr lang="en-US" altLang="zh-CN" dirty="0"/>
                <a:t>0.5</a:t>
              </a:r>
            </a:p>
            <a:p>
              <a:pPr>
                <a:lnSpc>
                  <a:spcPts val="1800"/>
                </a:lnSpc>
              </a:pPr>
              <a:r>
                <a:rPr lang="en-US" altLang="zh-CN" dirty="0"/>
                <a:t>0.25</a:t>
              </a:r>
            </a:p>
            <a:p>
              <a:pPr>
                <a:lnSpc>
                  <a:spcPts val="1800"/>
                </a:lnSpc>
              </a:pPr>
              <a:r>
                <a:rPr lang="en-US" altLang="zh-CN" dirty="0"/>
                <a:t>0.1</a:t>
              </a:r>
              <a:endParaRPr lang="zh-CN" altLang="en-US" dirty="0"/>
            </a:p>
          </p:txBody>
        </p:sp>
      </p:grpSp>
      <p:sp>
        <p:nvSpPr>
          <p:cNvPr id="9" name="内容占位符 2"/>
          <p:cNvSpPr txBox="1">
            <a:spLocks/>
          </p:cNvSpPr>
          <p:nvPr/>
        </p:nvSpPr>
        <p:spPr>
          <a:xfrm>
            <a:off x="0" y="0"/>
            <a:ext cx="2857488" cy="50004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 algn="ctr">
              <a:spcBef>
                <a:spcPct val="20000"/>
              </a:spcBef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Figure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lang="en-US" altLang="zh-CN" dirty="0" smtClean="0"/>
              <a:t>S</a:t>
            </a:r>
            <a:r>
              <a:rPr kumimoji="0" lang="en-US" altLang="zh-CN" sz="1800" b="0" i="0" u="none" strike="noStrike" kern="1200" cap="none" spc="0" normalizeH="0" noProof="0" dirty="0" smtClean="0">
                <a:ln>
                  <a:noFill/>
                </a:ln>
                <a:effectLst/>
                <a:uLnTx/>
                <a:uFillTx/>
                <a:latin typeface="+mn-lt"/>
                <a:ea typeface="+mn-ea"/>
                <a:cs typeface="+mn-cs"/>
              </a:rPr>
              <a:t>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内容占位符 2"/>
          <p:cNvSpPr>
            <a:spLocks noGrp="1"/>
          </p:cNvSpPr>
          <p:nvPr>
            <p:ph idx="1"/>
          </p:nvPr>
        </p:nvSpPr>
        <p:spPr>
          <a:xfrm>
            <a:off x="0" y="0"/>
            <a:ext cx="3357554" cy="471478"/>
          </a:xfrm>
        </p:spPr>
        <p:txBody>
          <a:bodyPr>
            <a:normAutofit/>
          </a:bodyPr>
          <a:lstStyle/>
          <a:p>
            <a:pPr>
              <a:buNone/>
            </a:pPr>
            <a:r>
              <a:rPr lang="en-US" altLang="zh-CN" sz="1800" dirty="0" smtClean="0"/>
              <a:t>Figure </a:t>
            </a:r>
            <a:r>
              <a:rPr lang="en-US" altLang="zh-CN" sz="1800" dirty="0" smtClean="0"/>
              <a:t>S6a</a:t>
            </a:r>
            <a:endParaRPr lang="zh-CN" altLang="en-US" sz="1800" dirty="0"/>
          </a:p>
        </p:txBody>
      </p:sp>
      <p:grpSp>
        <p:nvGrpSpPr>
          <p:cNvPr id="10" name="组合 9"/>
          <p:cNvGrpSpPr/>
          <p:nvPr/>
        </p:nvGrpSpPr>
        <p:grpSpPr>
          <a:xfrm>
            <a:off x="2143108" y="1428736"/>
            <a:ext cx="4505668" cy="4000528"/>
            <a:chOff x="1763926" y="1071546"/>
            <a:chExt cx="4889467" cy="4286280"/>
          </a:xfrm>
        </p:grpSpPr>
        <p:pic>
          <p:nvPicPr>
            <p:cNvPr id="5" name="图片 4" descr="图片1.jpg"/>
            <p:cNvPicPr>
              <a:picLocks noChangeAspect="1"/>
            </p:cNvPicPr>
            <p:nvPr/>
          </p:nvPicPr>
          <p:blipFill>
            <a:blip r:embed="rId2" cstate="print"/>
            <a:srcRect l="10356" t="9450" r="23042" b="5395"/>
            <a:stretch>
              <a:fillRect/>
            </a:stretch>
          </p:blipFill>
          <p:spPr>
            <a:xfrm flipH="1">
              <a:off x="2285984" y="1357298"/>
              <a:ext cx="4000528" cy="400052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60587" y="1071546"/>
              <a:ext cx="4792806" cy="395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Kb    M     1     2      3     4      5     6      7     8    </a:t>
              </a:r>
              <a:endParaRPr lang="zh-CN" alt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763926" y="3291227"/>
              <a:ext cx="593497" cy="18364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700"/>
                </a:lnSpc>
              </a:pPr>
              <a:r>
                <a:rPr lang="en-US" altLang="zh-CN" dirty="0"/>
                <a:t>2</a:t>
              </a:r>
            </a:p>
            <a:p>
              <a:pPr algn="r">
                <a:lnSpc>
                  <a:spcPts val="1700"/>
                </a:lnSpc>
              </a:pPr>
              <a:endParaRPr lang="en-US" altLang="zh-CN" dirty="0"/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1</a:t>
              </a:r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0.75</a:t>
              </a:r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0.5</a:t>
              </a:r>
            </a:p>
            <a:p>
              <a:pPr algn="r">
                <a:lnSpc>
                  <a:spcPts val="1700"/>
                </a:lnSpc>
              </a:pPr>
              <a:endParaRPr lang="en-US" altLang="zh-CN" dirty="0"/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0.25</a:t>
              </a:r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0.1</a:t>
              </a:r>
            </a:p>
          </p:txBody>
        </p:sp>
        <p:cxnSp>
          <p:nvCxnSpPr>
            <p:cNvPr id="9" name="直接箭头连接符 8"/>
            <p:cNvCxnSpPr/>
            <p:nvPr/>
          </p:nvCxnSpPr>
          <p:spPr>
            <a:xfrm rot="10800000">
              <a:off x="3571868" y="4071942"/>
              <a:ext cx="571504" cy="1588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内容占位符 2"/>
          <p:cNvSpPr>
            <a:spLocks noGrp="1"/>
          </p:cNvSpPr>
          <p:nvPr>
            <p:ph idx="1"/>
          </p:nvPr>
        </p:nvSpPr>
        <p:spPr>
          <a:xfrm>
            <a:off x="0" y="0"/>
            <a:ext cx="4286248" cy="471478"/>
          </a:xfrm>
        </p:spPr>
        <p:txBody>
          <a:bodyPr>
            <a:normAutofit/>
          </a:bodyPr>
          <a:lstStyle/>
          <a:p>
            <a:pPr>
              <a:buNone/>
            </a:pPr>
            <a:r>
              <a:rPr lang="en-US" altLang="zh-CN" sz="1800" dirty="0" smtClean="0"/>
              <a:t>Figure S6b</a:t>
            </a:r>
            <a:endParaRPr lang="zh-CN" altLang="en-US" sz="1800" dirty="0"/>
          </a:p>
        </p:txBody>
      </p:sp>
      <p:grpSp>
        <p:nvGrpSpPr>
          <p:cNvPr id="13" name="组合 12"/>
          <p:cNvGrpSpPr/>
          <p:nvPr/>
        </p:nvGrpSpPr>
        <p:grpSpPr>
          <a:xfrm>
            <a:off x="2049678" y="987966"/>
            <a:ext cx="4451148" cy="4512736"/>
            <a:chOff x="2049678" y="916528"/>
            <a:chExt cx="4451148" cy="4512736"/>
          </a:xfrm>
        </p:grpSpPr>
        <p:pic>
          <p:nvPicPr>
            <p:cNvPr id="4" name="图片 3" descr="20141026.jpg"/>
            <p:cNvPicPr>
              <a:picLocks noChangeAspect="1"/>
            </p:cNvPicPr>
            <p:nvPr/>
          </p:nvPicPr>
          <p:blipFill>
            <a:blip r:embed="rId2" cstate="print"/>
            <a:srcRect l="28333" r="27500" b="36458"/>
            <a:stretch>
              <a:fillRect/>
            </a:stretch>
          </p:blipFill>
          <p:spPr>
            <a:xfrm>
              <a:off x="2571736" y="1214422"/>
              <a:ext cx="3786214" cy="4214842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143108" y="916528"/>
              <a:ext cx="42148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Kb     M    1      2     3     4            5    6     7    8     </a:t>
              </a:r>
              <a:endParaRPr lang="zh-CN" alt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049678" y="2786058"/>
              <a:ext cx="593496" cy="24904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700"/>
                </a:lnSpc>
              </a:pPr>
              <a:r>
                <a:rPr lang="en-US" altLang="zh-CN" dirty="0"/>
                <a:t>2</a:t>
              </a:r>
            </a:p>
            <a:p>
              <a:pPr algn="r">
                <a:lnSpc>
                  <a:spcPts val="1700"/>
                </a:lnSpc>
              </a:pPr>
              <a:endParaRPr lang="en-US" altLang="zh-CN" dirty="0"/>
            </a:p>
            <a:p>
              <a:pPr algn="r">
                <a:lnSpc>
                  <a:spcPts val="1700"/>
                </a:lnSpc>
              </a:pPr>
              <a:endParaRPr lang="en-US" altLang="zh-CN" dirty="0"/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1</a:t>
              </a:r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0.75</a:t>
              </a:r>
            </a:p>
            <a:p>
              <a:pPr algn="r">
                <a:lnSpc>
                  <a:spcPts val="1700"/>
                </a:lnSpc>
              </a:pPr>
              <a:endParaRPr lang="en-US" altLang="zh-CN" dirty="0"/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0.5</a:t>
              </a:r>
            </a:p>
            <a:p>
              <a:pPr algn="r">
                <a:lnSpc>
                  <a:spcPts val="1700"/>
                </a:lnSpc>
              </a:pPr>
              <a:endParaRPr lang="en-US" altLang="zh-CN" dirty="0"/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>0.25</a:t>
              </a:r>
            </a:p>
            <a:p>
              <a:pPr algn="r">
                <a:lnSpc>
                  <a:spcPts val="1700"/>
                </a:lnSpc>
              </a:pPr>
              <a:r>
                <a:rPr lang="en-US" altLang="zh-CN" dirty="0"/>
                <a:t/>
              </a:r>
              <a:br>
                <a:rPr lang="en-US" altLang="zh-CN" dirty="0"/>
              </a:br>
              <a:r>
                <a:rPr lang="en-US" altLang="zh-CN" dirty="0"/>
                <a:t>0.1</a:t>
              </a:r>
            </a:p>
          </p:txBody>
        </p:sp>
        <p:cxnSp>
          <p:nvCxnSpPr>
            <p:cNvPr id="9" name="直接箭头连接符 8"/>
            <p:cNvCxnSpPr/>
            <p:nvPr/>
          </p:nvCxnSpPr>
          <p:spPr>
            <a:xfrm rot="10800000">
              <a:off x="5929322" y="3786190"/>
              <a:ext cx="571504" cy="1588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3" name="AutoShape 63"/>
          <p:cNvSpPr>
            <a:spLocks noChangeAspect="1" noChangeArrowheads="1" noTextEdit="1"/>
          </p:cNvSpPr>
          <p:nvPr/>
        </p:nvSpPr>
        <p:spPr bwMode="auto">
          <a:xfrm>
            <a:off x="762000" y="228600"/>
            <a:ext cx="7593013" cy="635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zh-CN" altLang="en-US"/>
          </a:p>
        </p:txBody>
      </p:sp>
      <p:grpSp>
        <p:nvGrpSpPr>
          <p:cNvPr id="2" name="Group 119"/>
          <p:cNvGrpSpPr>
            <a:grpSpLocks/>
          </p:cNvGrpSpPr>
          <p:nvPr/>
        </p:nvGrpSpPr>
        <p:grpSpPr bwMode="auto">
          <a:xfrm>
            <a:off x="798513" y="255588"/>
            <a:ext cx="7542212" cy="6249987"/>
            <a:chOff x="503" y="161"/>
            <a:chExt cx="4751" cy="3937"/>
          </a:xfrm>
        </p:grpSpPr>
        <p:sp>
          <p:nvSpPr>
            <p:cNvPr id="5185" name="Freeform 65"/>
            <p:cNvSpPr>
              <a:spLocks/>
            </p:cNvSpPr>
            <p:nvPr/>
          </p:nvSpPr>
          <p:spPr bwMode="auto">
            <a:xfrm>
              <a:off x="1099" y="670"/>
              <a:ext cx="3429" cy="3428"/>
            </a:xfrm>
            <a:custGeom>
              <a:avLst/>
              <a:gdLst/>
              <a:ahLst/>
              <a:cxnLst>
                <a:cxn ang="0">
                  <a:pos x="1112" y="18"/>
                </a:cxn>
                <a:cxn ang="0">
                  <a:pos x="769" y="125"/>
                </a:cxn>
                <a:cxn ang="0">
                  <a:pos x="468" y="320"/>
                </a:cxn>
                <a:cxn ang="0">
                  <a:pos x="230" y="588"/>
                </a:cxn>
                <a:cxn ang="0">
                  <a:pos x="69" y="908"/>
                </a:cxn>
                <a:cxn ang="0">
                  <a:pos x="1" y="1260"/>
                </a:cxn>
                <a:cxn ang="0">
                  <a:pos x="28" y="1617"/>
                </a:cxn>
                <a:cxn ang="0">
                  <a:pos x="149" y="1954"/>
                </a:cxn>
                <a:cxn ang="0">
                  <a:pos x="355" y="2249"/>
                </a:cxn>
                <a:cxn ang="0">
                  <a:pos x="632" y="2477"/>
                </a:cxn>
                <a:cxn ang="0">
                  <a:pos x="958" y="2623"/>
                </a:cxn>
                <a:cxn ang="0">
                  <a:pos x="1313" y="2678"/>
                </a:cxn>
                <a:cxn ang="0">
                  <a:pos x="1669" y="2637"/>
                </a:cxn>
                <a:cxn ang="0">
                  <a:pos x="2001" y="2502"/>
                </a:cxn>
                <a:cxn ang="0">
                  <a:pos x="2287" y="2285"/>
                </a:cxn>
                <a:cxn ang="0">
                  <a:pos x="2505" y="2001"/>
                </a:cxn>
                <a:cxn ang="0">
                  <a:pos x="2638" y="1668"/>
                </a:cxn>
                <a:cxn ang="0">
                  <a:pos x="2679" y="1312"/>
                </a:cxn>
                <a:cxn ang="0">
                  <a:pos x="2624" y="958"/>
                </a:cxn>
                <a:cxn ang="0">
                  <a:pos x="2477" y="632"/>
                </a:cxn>
                <a:cxn ang="0">
                  <a:pos x="2249" y="355"/>
                </a:cxn>
                <a:cxn ang="0">
                  <a:pos x="1956" y="148"/>
                </a:cxn>
                <a:cxn ang="0">
                  <a:pos x="1617" y="29"/>
                </a:cxn>
                <a:cxn ang="0">
                  <a:pos x="1353" y="0"/>
                </a:cxn>
                <a:cxn ang="0">
                  <a:pos x="1587" y="48"/>
                </a:cxn>
                <a:cxn ang="0">
                  <a:pos x="1920" y="160"/>
                </a:cxn>
                <a:cxn ang="0">
                  <a:pos x="2211" y="357"/>
                </a:cxn>
                <a:cxn ang="0">
                  <a:pos x="2441" y="623"/>
                </a:cxn>
                <a:cxn ang="0">
                  <a:pos x="2591" y="940"/>
                </a:cxn>
                <a:cxn ang="0">
                  <a:pos x="2653" y="1286"/>
                </a:cxn>
                <a:cxn ang="0">
                  <a:pos x="2620" y="1637"/>
                </a:cxn>
                <a:cxn ang="0">
                  <a:pos x="2494" y="1964"/>
                </a:cxn>
                <a:cxn ang="0">
                  <a:pos x="2287" y="2249"/>
                </a:cxn>
                <a:cxn ang="0">
                  <a:pos x="2012" y="2468"/>
                </a:cxn>
                <a:cxn ang="0">
                  <a:pos x="1688" y="2605"/>
                </a:cxn>
                <a:cxn ang="0">
                  <a:pos x="1341" y="2652"/>
                </a:cxn>
                <a:cxn ang="0">
                  <a:pos x="991" y="2605"/>
                </a:cxn>
                <a:cxn ang="0">
                  <a:pos x="668" y="2468"/>
                </a:cxn>
                <a:cxn ang="0">
                  <a:pos x="393" y="2250"/>
                </a:cxn>
                <a:cxn ang="0">
                  <a:pos x="184" y="1966"/>
                </a:cxn>
                <a:cxn ang="0">
                  <a:pos x="59" y="1638"/>
                </a:cxn>
                <a:cxn ang="0">
                  <a:pos x="25" y="1288"/>
                </a:cxn>
                <a:cxn ang="0">
                  <a:pos x="86" y="941"/>
                </a:cxn>
                <a:cxn ang="0">
                  <a:pos x="236" y="624"/>
                </a:cxn>
                <a:cxn ang="0">
                  <a:pos x="465" y="357"/>
                </a:cxn>
                <a:cxn ang="0">
                  <a:pos x="757" y="160"/>
                </a:cxn>
                <a:cxn ang="0">
                  <a:pos x="1090" y="48"/>
                </a:cxn>
                <a:cxn ang="0">
                  <a:pos x="1350" y="26"/>
                </a:cxn>
              </a:cxnLst>
              <a:rect l="0" t="0" r="r" b="b"/>
              <a:pathLst>
                <a:path w="2679" h="2678">
                  <a:moveTo>
                    <a:pt x="1350" y="0"/>
                  </a:moveTo>
                  <a:lnTo>
                    <a:pt x="1230" y="3"/>
                  </a:lnTo>
                  <a:lnTo>
                    <a:pt x="1112" y="18"/>
                  </a:lnTo>
                  <a:lnTo>
                    <a:pt x="994" y="44"/>
                  </a:lnTo>
                  <a:lnTo>
                    <a:pt x="881" y="80"/>
                  </a:lnTo>
                  <a:lnTo>
                    <a:pt x="769" y="125"/>
                  </a:lnTo>
                  <a:lnTo>
                    <a:pt x="663" y="181"/>
                  </a:lnTo>
                  <a:lnTo>
                    <a:pt x="564" y="246"/>
                  </a:lnTo>
                  <a:lnTo>
                    <a:pt x="468" y="320"/>
                  </a:lnTo>
                  <a:lnTo>
                    <a:pt x="381" y="402"/>
                  </a:lnTo>
                  <a:lnTo>
                    <a:pt x="301" y="491"/>
                  </a:lnTo>
                  <a:lnTo>
                    <a:pt x="230" y="588"/>
                  </a:lnTo>
                  <a:lnTo>
                    <a:pt x="168" y="689"/>
                  </a:lnTo>
                  <a:lnTo>
                    <a:pt x="113" y="796"/>
                  </a:lnTo>
                  <a:lnTo>
                    <a:pt x="69" y="908"/>
                  </a:lnTo>
                  <a:lnTo>
                    <a:pt x="36" y="1023"/>
                  </a:lnTo>
                  <a:lnTo>
                    <a:pt x="13" y="1141"/>
                  </a:lnTo>
                  <a:lnTo>
                    <a:pt x="1" y="1260"/>
                  </a:lnTo>
                  <a:lnTo>
                    <a:pt x="0" y="1380"/>
                  </a:lnTo>
                  <a:lnTo>
                    <a:pt x="9" y="1499"/>
                  </a:lnTo>
                  <a:lnTo>
                    <a:pt x="28" y="1617"/>
                  </a:lnTo>
                  <a:lnTo>
                    <a:pt x="59" y="1733"/>
                  </a:lnTo>
                  <a:lnTo>
                    <a:pt x="100" y="1845"/>
                  </a:lnTo>
                  <a:lnTo>
                    <a:pt x="149" y="1954"/>
                  </a:lnTo>
                  <a:lnTo>
                    <a:pt x="208" y="2058"/>
                  </a:lnTo>
                  <a:lnTo>
                    <a:pt x="278" y="2156"/>
                  </a:lnTo>
                  <a:lnTo>
                    <a:pt x="355" y="2249"/>
                  </a:lnTo>
                  <a:lnTo>
                    <a:pt x="440" y="2332"/>
                  </a:lnTo>
                  <a:lnTo>
                    <a:pt x="533" y="2409"/>
                  </a:lnTo>
                  <a:lnTo>
                    <a:pt x="632" y="2477"/>
                  </a:lnTo>
                  <a:lnTo>
                    <a:pt x="736" y="2534"/>
                  </a:lnTo>
                  <a:lnTo>
                    <a:pt x="845" y="2584"/>
                  </a:lnTo>
                  <a:lnTo>
                    <a:pt x="958" y="2623"/>
                  </a:lnTo>
                  <a:lnTo>
                    <a:pt x="1075" y="2652"/>
                  </a:lnTo>
                  <a:lnTo>
                    <a:pt x="1194" y="2670"/>
                  </a:lnTo>
                  <a:lnTo>
                    <a:pt x="1313" y="2678"/>
                  </a:lnTo>
                  <a:lnTo>
                    <a:pt x="1433" y="2675"/>
                  </a:lnTo>
                  <a:lnTo>
                    <a:pt x="1552" y="2661"/>
                  </a:lnTo>
                  <a:lnTo>
                    <a:pt x="1669" y="2637"/>
                  </a:lnTo>
                  <a:lnTo>
                    <a:pt x="1784" y="2602"/>
                  </a:lnTo>
                  <a:lnTo>
                    <a:pt x="1895" y="2557"/>
                  </a:lnTo>
                  <a:lnTo>
                    <a:pt x="2001" y="2502"/>
                  </a:lnTo>
                  <a:lnTo>
                    <a:pt x="2103" y="2439"/>
                  </a:lnTo>
                  <a:lnTo>
                    <a:pt x="2198" y="2366"/>
                  </a:lnTo>
                  <a:lnTo>
                    <a:pt x="2287" y="2285"/>
                  </a:lnTo>
                  <a:lnTo>
                    <a:pt x="2367" y="2197"/>
                  </a:lnTo>
                  <a:lnTo>
                    <a:pt x="2440" y="2102"/>
                  </a:lnTo>
                  <a:lnTo>
                    <a:pt x="2505" y="2001"/>
                  </a:lnTo>
                  <a:lnTo>
                    <a:pt x="2559" y="1893"/>
                  </a:lnTo>
                  <a:lnTo>
                    <a:pt x="2603" y="1783"/>
                  </a:lnTo>
                  <a:lnTo>
                    <a:pt x="2638" y="1668"/>
                  </a:lnTo>
                  <a:lnTo>
                    <a:pt x="2662" y="1550"/>
                  </a:lnTo>
                  <a:lnTo>
                    <a:pt x="2676" y="1433"/>
                  </a:lnTo>
                  <a:lnTo>
                    <a:pt x="2679" y="1312"/>
                  </a:lnTo>
                  <a:lnTo>
                    <a:pt x="2671" y="1192"/>
                  </a:lnTo>
                  <a:lnTo>
                    <a:pt x="2653" y="1074"/>
                  </a:lnTo>
                  <a:lnTo>
                    <a:pt x="2624" y="958"/>
                  </a:lnTo>
                  <a:lnTo>
                    <a:pt x="2585" y="845"/>
                  </a:lnTo>
                  <a:lnTo>
                    <a:pt x="2536" y="736"/>
                  </a:lnTo>
                  <a:lnTo>
                    <a:pt x="2477" y="632"/>
                  </a:lnTo>
                  <a:lnTo>
                    <a:pt x="2409" y="532"/>
                  </a:lnTo>
                  <a:lnTo>
                    <a:pt x="2334" y="440"/>
                  </a:lnTo>
                  <a:lnTo>
                    <a:pt x="2249" y="355"/>
                  </a:lnTo>
                  <a:lnTo>
                    <a:pt x="2157" y="278"/>
                  </a:lnTo>
                  <a:lnTo>
                    <a:pt x="2059" y="209"/>
                  </a:lnTo>
                  <a:lnTo>
                    <a:pt x="1956" y="148"/>
                  </a:lnTo>
                  <a:lnTo>
                    <a:pt x="1847" y="98"/>
                  </a:lnTo>
                  <a:lnTo>
                    <a:pt x="1734" y="57"/>
                  </a:lnTo>
                  <a:lnTo>
                    <a:pt x="1617" y="29"/>
                  </a:lnTo>
                  <a:lnTo>
                    <a:pt x="1499" y="9"/>
                  </a:lnTo>
                  <a:lnTo>
                    <a:pt x="1380" y="0"/>
                  </a:lnTo>
                  <a:lnTo>
                    <a:pt x="1353" y="0"/>
                  </a:lnTo>
                  <a:lnTo>
                    <a:pt x="1353" y="26"/>
                  </a:lnTo>
                  <a:lnTo>
                    <a:pt x="1471" y="32"/>
                  </a:lnTo>
                  <a:lnTo>
                    <a:pt x="1587" y="48"/>
                  </a:lnTo>
                  <a:lnTo>
                    <a:pt x="1700" y="76"/>
                  </a:lnTo>
                  <a:lnTo>
                    <a:pt x="1812" y="113"/>
                  </a:lnTo>
                  <a:lnTo>
                    <a:pt x="1920" y="160"/>
                  </a:lnTo>
                  <a:lnTo>
                    <a:pt x="2022" y="216"/>
                  </a:lnTo>
                  <a:lnTo>
                    <a:pt x="2121" y="283"/>
                  </a:lnTo>
                  <a:lnTo>
                    <a:pt x="2211" y="357"/>
                  </a:lnTo>
                  <a:lnTo>
                    <a:pt x="2296" y="438"/>
                  </a:lnTo>
                  <a:lnTo>
                    <a:pt x="2373" y="527"/>
                  </a:lnTo>
                  <a:lnTo>
                    <a:pt x="2441" y="623"/>
                  </a:lnTo>
                  <a:lnTo>
                    <a:pt x="2500" y="724"/>
                  </a:lnTo>
                  <a:lnTo>
                    <a:pt x="2552" y="830"/>
                  </a:lnTo>
                  <a:lnTo>
                    <a:pt x="2591" y="940"/>
                  </a:lnTo>
                  <a:lnTo>
                    <a:pt x="2623" y="1053"/>
                  </a:lnTo>
                  <a:lnTo>
                    <a:pt x="2642" y="1170"/>
                  </a:lnTo>
                  <a:lnTo>
                    <a:pt x="2653" y="1286"/>
                  </a:lnTo>
                  <a:lnTo>
                    <a:pt x="2651" y="1404"/>
                  </a:lnTo>
                  <a:lnTo>
                    <a:pt x="2641" y="1520"/>
                  </a:lnTo>
                  <a:lnTo>
                    <a:pt x="2620" y="1637"/>
                  </a:lnTo>
                  <a:lnTo>
                    <a:pt x="2588" y="1748"/>
                  </a:lnTo>
                  <a:lnTo>
                    <a:pt x="2546" y="1859"/>
                  </a:lnTo>
                  <a:lnTo>
                    <a:pt x="2494" y="1964"/>
                  </a:lnTo>
                  <a:lnTo>
                    <a:pt x="2434" y="2066"/>
                  </a:lnTo>
                  <a:lnTo>
                    <a:pt x="2364" y="2159"/>
                  </a:lnTo>
                  <a:lnTo>
                    <a:pt x="2287" y="2249"/>
                  </a:lnTo>
                  <a:lnTo>
                    <a:pt x="2202" y="2329"/>
                  </a:lnTo>
                  <a:lnTo>
                    <a:pt x="2110" y="2403"/>
                  </a:lnTo>
                  <a:lnTo>
                    <a:pt x="2012" y="2468"/>
                  </a:lnTo>
                  <a:lnTo>
                    <a:pt x="1908" y="2522"/>
                  </a:lnTo>
                  <a:lnTo>
                    <a:pt x="1800" y="2569"/>
                  </a:lnTo>
                  <a:lnTo>
                    <a:pt x="1688" y="2605"/>
                  </a:lnTo>
                  <a:lnTo>
                    <a:pt x="1573" y="2631"/>
                  </a:lnTo>
                  <a:lnTo>
                    <a:pt x="1457" y="2648"/>
                  </a:lnTo>
                  <a:lnTo>
                    <a:pt x="1341" y="2652"/>
                  </a:lnTo>
                  <a:lnTo>
                    <a:pt x="1223" y="2648"/>
                  </a:lnTo>
                  <a:lnTo>
                    <a:pt x="1106" y="2631"/>
                  </a:lnTo>
                  <a:lnTo>
                    <a:pt x="991" y="2605"/>
                  </a:lnTo>
                  <a:lnTo>
                    <a:pt x="880" y="2569"/>
                  </a:lnTo>
                  <a:lnTo>
                    <a:pt x="772" y="2524"/>
                  </a:lnTo>
                  <a:lnTo>
                    <a:pt x="668" y="2468"/>
                  </a:lnTo>
                  <a:lnTo>
                    <a:pt x="570" y="2403"/>
                  </a:lnTo>
                  <a:lnTo>
                    <a:pt x="477" y="2330"/>
                  </a:lnTo>
                  <a:lnTo>
                    <a:pt x="393" y="2250"/>
                  </a:lnTo>
                  <a:lnTo>
                    <a:pt x="314" y="2161"/>
                  </a:lnTo>
                  <a:lnTo>
                    <a:pt x="245" y="2067"/>
                  </a:lnTo>
                  <a:lnTo>
                    <a:pt x="184" y="1966"/>
                  </a:lnTo>
                  <a:lnTo>
                    <a:pt x="133" y="1860"/>
                  </a:lnTo>
                  <a:lnTo>
                    <a:pt x="92" y="1751"/>
                  </a:lnTo>
                  <a:lnTo>
                    <a:pt x="59" y="1638"/>
                  </a:lnTo>
                  <a:lnTo>
                    <a:pt x="38" y="1522"/>
                  </a:lnTo>
                  <a:lnTo>
                    <a:pt x="27" y="1405"/>
                  </a:lnTo>
                  <a:lnTo>
                    <a:pt x="25" y="1288"/>
                  </a:lnTo>
                  <a:lnTo>
                    <a:pt x="36" y="1171"/>
                  </a:lnTo>
                  <a:lnTo>
                    <a:pt x="56" y="1055"/>
                  </a:lnTo>
                  <a:lnTo>
                    <a:pt x="86" y="941"/>
                  </a:lnTo>
                  <a:lnTo>
                    <a:pt x="127" y="831"/>
                  </a:lnTo>
                  <a:lnTo>
                    <a:pt x="177" y="725"/>
                  </a:lnTo>
                  <a:lnTo>
                    <a:pt x="236" y="624"/>
                  </a:lnTo>
                  <a:lnTo>
                    <a:pt x="305" y="527"/>
                  </a:lnTo>
                  <a:lnTo>
                    <a:pt x="381" y="438"/>
                  </a:lnTo>
                  <a:lnTo>
                    <a:pt x="465" y="357"/>
                  </a:lnTo>
                  <a:lnTo>
                    <a:pt x="556" y="283"/>
                  </a:lnTo>
                  <a:lnTo>
                    <a:pt x="654" y="218"/>
                  </a:lnTo>
                  <a:lnTo>
                    <a:pt x="757" y="160"/>
                  </a:lnTo>
                  <a:lnTo>
                    <a:pt x="864" y="113"/>
                  </a:lnTo>
                  <a:lnTo>
                    <a:pt x="976" y="76"/>
                  </a:lnTo>
                  <a:lnTo>
                    <a:pt x="1090" y="48"/>
                  </a:lnTo>
                  <a:lnTo>
                    <a:pt x="1206" y="32"/>
                  </a:lnTo>
                  <a:lnTo>
                    <a:pt x="1324" y="24"/>
                  </a:lnTo>
                  <a:lnTo>
                    <a:pt x="1350" y="26"/>
                  </a:lnTo>
                  <a:lnTo>
                    <a:pt x="1350" y="0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86" name="Oval 66"/>
            <p:cNvSpPr>
              <a:spLocks noChangeArrowheads="1"/>
            </p:cNvSpPr>
            <p:nvPr/>
          </p:nvSpPr>
          <p:spPr bwMode="auto">
            <a:xfrm>
              <a:off x="1099" y="670"/>
              <a:ext cx="3429" cy="3428"/>
            </a:xfrm>
            <a:prstGeom prst="ellips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87" name="Oval 67"/>
            <p:cNvSpPr>
              <a:spLocks noChangeArrowheads="1"/>
            </p:cNvSpPr>
            <p:nvPr/>
          </p:nvSpPr>
          <p:spPr bwMode="auto">
            <a:xfrm>
              <a:off x="1131" y="703"/>
              <a:ext cx="3364" cy="3362"/>
            </a:xfrm>
            <a:prstGeom prst="ellips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88" name="Line 68"/>
            <p:cNvSpPr>
              <a:spLocks noChangeShapeType="1"/>
            </p:cNvSpPr>
            <p:nvPr/>
          </p:nvSpPr>
          <p:spPr bwMode="auto">
            <a:xfrm flipV="1">
              <a:off x="2827" y="670"/>
              <a:ext cx="0" cy="3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89" name="Rectangle 69"/>
            <p:cNvSpPr>
              <a:spLocks noChangeArrowheads="1"/>
            </p:cNvSpPr>
            <p:nvPr/>
          </p:nvSpPr>
          <p:spPr bwMode="auto">
            <a:xfrm>
              <a:off x="2454" y="2256"/>
              <a:ext cx="666" cy="1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>
                  <a:solidFill>
                    <a:srgbClr val="000000"/>
                  </a:solidFill>
                </a:rPr>
                <a:t>pC35ST-CfJMT</a:t>
              </a:r>
              <a:endParaRPr lang="en-US" altLang="zh-CN"/>
            </a:p>
          </p:txBody>
        </p:sp>
        <p:sp>
          <p:nvSpPr>
            <p:cNvPr id="5190" name="Rectangle 70"/>
            <p:cNvSpPr>
              <a:spLocks noChangeArrowheads="1"/>
            </p:cNvSpPr>
            <p:nvPr/>
          </p:nvSpPr>
          <p:spPr bwMode="auto">
            <a:xfrm>
              <a:off x="2661" y="2407"/>
              <a:ext cx="299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11174 bp</a:t>
              </a:r>
              <a:endParaRPr lang="en-US" altLang="zh-CN"/>
            </a:p>
          </p:txBody>
        </p:sp>
        <p:sp>
          <p:nvSpPr>
            <p:cNvPr id="5191" name="Freeform 71"/>
            <p:cNvSpPr>
              <a:spLocks/>
            </p:cNvSpPr>
            <p:nvPr/>
          </p:nvSpPr>
          <p:spPr bwMode="auto">
            <a:xfrm>
              <a:off x="2831" y="575"/>
              <a:ext cx="270" cy="228"/>
            </a:xfrm>
            <a:custGeom>
              <a:avLst/>
              <a:gdLst/>
              <a:ahLst/>
              <a:cxnLst>
                <a:cxn ang="0">
                  <a:pos x="211" y="56"/>
                </a:cxn>
                <a:cxn ang="0">
                  <a:pos x="90" y="39"/>
                </a:cxn>
                <a:cxn ang="0">
                  <a:pos x="83" y="39"/>
                </a:cxn>
                <a:cxn ang="0">
                  <a:pos x="86" y="0"/>
                </a:cxn>
                <a:cxn ang="0">
                  <a:pos x="0" y="86"/>
                </a:cxn>
                <a:cxn ang="0">
                  <a:pos x="72" y="178"/>
                </a:cxn>
                <a:cxn ang="0">
                  <a:pos x="75" y="139"/>
                </a:cxn>
                <a:cxn ang="0">
                  <a:pos x="189" y="151"/>
                </a:cxn>
                <a:cxn ang="0">
                  <a:pos x="196" y="154"/>
                </a:cxn>
                <a:cxn ang="0">
                  <a:pos x="211" y="56"/>
                </a:cxn>
              </a:cxnLst>
              <a:rect l="0" t="0" r="r" b="b"/>
              <a:pathLst>
                <a:path w="211" h="178">
                  <a:moveTo>
                    <a:pt x="211" y="56"/>
                  </a:moveTo>
                  <a:lnTo>
                    <a:pt x="90" y="39"/>
                  </a:lnTo>
                  <a:lnTo>
                    <a:pt x="83" y="39"/>
                  </a:lnTo>
                  <a:lnTo>
                    <a:pt x="86" y="0"/>
                  </a:lnTo>
                  <a:lnTo>
                    <a:pt x="0" y="86"/>
                  </a:lnTo>
                  <a:lnTo>
                    <a:pt x="72" y="178"/>
                  </a:lnTo>
                  <a:lnTo>
                    <a:pt x="75" y="139"/>
                  </a:lnTo>
                  <a:lnTo>
                    <a:pt x="189" y="151"/>
                  </a:lnTo>
                  <a:lnTo>
                    <a:pt x="196" y="154"/>
                  </a:lnTo>
                  <a:lnTo>
                    <a:pt x="211" y="56"/>
                  </a:lnTo>
                  <a:close/>
                </a:path>
              </a:pathLst>
            </a:custGeom>
            <a:pattFill prst="ltUpDiag">
              <a:fgClr>
                <a:srgbClr val="000000"/>
              </a:fgClr>
              <a:bgClr>
                <a:srgbClr val="FFFFFF"/>
              </a:bgClr>
            </a:patt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92" name="Arc 72"/>
            <p:cNvSpPr>
              <a:spLocks/>
            </p:cNvSpPr>
            <p:nvPr/>
          </p:nvSpPr>
          <p:spPr bwMode="auto">
            <a:xfrm>
              <a:off x="2813" y="625"/>
              <a:ext cx="288" cy="1758"/>
            </a:xfrm>
            <a:custGeom>
              <a:avLst/>
              <a:gdLst>
                <a:gd name="G0" fmla="+- 0 0 0"/>
                <a:gd name="G1" fmla="+- 21546 0 0"/>
                <a:gd name="G2" fmla="+- 21600 0 0"/>
                <a:gd name="T0" fmla="*/ 1522 w 3536"/>
                <a:gd name="T1" fmla="*/ 0 h 21546"/>
                <a:gd name="T2" fmla="*/ 3536 w 3536"/>
                <a:gd name="T3" fmla="*/ 237 h 21546"/>
                <a:gd name="T4" fmla="*/ 0 w 3536"/>
                <a:gd name="T5" fmla="*/ 21546 h 215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36" h="21546" fill="none" extrusionOk="0">
                  <a:moveTo>
                    <a:pt x="1522" y="-1"/>
                  </a:moveTo>
                  <a:cubicBezTo>
                    <a:pt x="2196" y="47"/>
                    <a:pt x="2868" y="126"/>
                    <a:pt x="3535" y="237"/>
                  </a:cubicBezTo>
                </a:path>
                <a:path w="3536" h="21546" stroke="0" extrusionOk="0">
                  <a:moveTo>
                    <a:pt x="1522" y="-1"/>
                  </a:moveTo>
                  <a:cubicBezTo>
                    <a:pt x="2196" y="47"/>
                    <a:pt x="2868" y="126"/>
                    <a:pt x="3535" y="237"/>
                  </a:cubicBezTo>
                  <a:lnTo>
                    <a:pt x="0" y="21546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93" name="Arc 73"/>
            <p:cNvSpPr>
              <a:spLocks/>
            </p:cNvSpPr>
            <p:nvPr/>
          </p:nvSpPr>
          <p:spPr bwMode="auto">
            <a:xfrm>
              <a:off x="2815" y="753"/>
              <a:ext cx="267" cy="1630"/>
            </a:xfrm>
            <a:custGeom>
              <a:avLst/>
              <a:gdLst>
                <a:gd name="G0" fmla="+- 0 0 0"/>
                <a:gd name="G1" fmla="+- 21549 0 0"/>
                <a:gd name="G2" fmla="+- 21600 0 0"/>
                <a:gd name="T0" fmla="*/ 1488 w 3536"/>
                <a:gd name="T1" fmla="*/ 0 h 21549"/>
                <a:gd name="T2" fmla="*/ 3536 w 3536"/>
                <a:gd name="T3" fmla="*/ 240 h 21549"/>
                <a:gd name="T4" fmla="*/ 0 w 3536"/>
                <a:gd name="T5" fmla="*/ 21549 h 215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36" h="21549" fill="none" extrusionOk="0">
                  <a:moveTo>
                    <a:pt x="1487" y="0"/>
                  </a:moveTo>
                  <a:cubicBezTo>
                    <a:pt x="2174" y="47"/>
                    <a:pt x="2857" y="127"/>
                    <a:pt x="3535" y="240"/>
                  </a:cubicBezTo>
                </a:path>
                <a:path w="3536" h="21549" stroke="0" extrusionOk="0">
                  <a:moveTo>
                    <a:pt x="1487" y="0"/>
                  </a:moveTo>
                  <a:cubicBezTo>
                    <a:pt x="2174" y="47"/>
                    <a:pt x="2857" y="127"/>
                    <a:pt x="3535" y="240"/>
                  </a:cubicBezTo>
                  <a:lnTo>
                    <a:pt x="0" y="21549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94" name="Line 74"/>
            <p:cNvSpPr>
              <a:spLocks noChangeShapeType="1"/>
            </p:cNvSpPr>
            <p:nvPr/>
          </p:nvSpPr>
          <p:spPr bwMode="auto">
            <a:xfrm flipV="1">
              <a:off x="3082" y="647"/>
              <a:ext cx="19" cy="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95" name="Freeform 75"/>
            <p:cNvSpPr>
              <a:spLocks/>
            </p:cNvSpPr>
            <p:nvPr/>
          </p:nvSpPr>
          <p:spPr bwMode="auto">
            <a:xfrm>
              <a:off x="2831" y="575"/>
              <a:ext cx="110" cy="228"/>
            </a:xfrm>
            <a:custGeom>
              <a:avLst/>
              <a:gdLst/>
              <a:ahLst/>
              <a:cxnLst>
                <a:cxn ang="0">
                  <a:pos x="50" y="92"/>
                </a:cxn>
                <a:cxn ang="0">
                  <a:pos x="48" y="118"/>
                </a:cxn>
                <a:cxn ang="0">
                  <a:pos x="0" y="57"/>
                </a:cxn>
                <a:cxn ang="0">
                  <a:pos x="57" y="0"/>
                </a:cxn>
                <a:cxn ang="0">
                  <a:pos x="55" y="26"/>
                </a:cxn>
              </a:cxnLst>
              <a:rect l="0" t="0" r="r" b="b"/>
              <a:pathLst>
                <a:path w="57" h="118">
                  <a:moveTo>
                    <a:pt x="50" y="92"/>
                  </a:moveTo>
                  <a:lnTo>
                    <a:pt x="48" y="118"/>
                  </a:lnTo>
                  <a:lnTo>
                    <a:pt x="0" y="57"/>
                  </a:lnTo>
                  <a:lnTo>
                    <a:pt x="57" y="0"/>
                  </a:lnTo>
                  <a:lnTo>
                    <a:pt x="55" y="2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96" name="Line 76"/>
            <p:cNvSpPr>
              <a:spLocks noChangeShapeType="1"/>
            </p:cNvSpPr>
            <p:nvPr/>
          </p:nvSpPr>
          <p:spPr bwMode="auto">
            <a:xfrm flipH="1">
              <a:off x="2968" y="408"/>
              <a:ext cx="169" cy="22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97" name="Rectangle 77"/>
            <p:cNvSpPr>
              <a:spLocks noChangeArrowheads="1"/>
            </p:cNvSpPr>
            <p:nvPr/>
          </p:nvSpPr>
          <p:spPr bwMode="auto">
            <a:xfrm>
              <a:off x="3142" y="286"/>
              <a:ext cx="644" cy="1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>
                  <a:solidFill>
                    <a:srgbClr val="000000"/>
                  </a:solidFill>
                </a:rPr>
                <a:t>nos Terminator</a:t>
              </a:r>
              <a:endParaRPr lang="en-US" altLang="zh-CN"/>
            </a:p>
          </p:txBody>
        </p:sp>
        <p:sp>
          <p:nvSpPr>
            <p:cNvPr id="5198" name="Freeform 78"/>
            <p:cNvSpPr>
              <a:spLocks/>
            </p:cNvSpPr>
            <p:nvPr/>
          </p:nvSpPr>
          <p:spPr bwMode="auto">
            <a:xfrm>
              <a:off x="4009" y="1196"/>
              <a:ext cx="495" cy="727"/>
            </a:xfrm>
            <a:custGeom>
              <a:avLst/>
              <a:gdLst/>
              <a:ahLst/>
              <a:cxnLst>
                <a:cxn ang="0">
                  <a:pos x="387" y="540"/>
                </a:cxn>
                <a:cxn ang="0">
                  <a:pos x="348" y="423"/>
                </a:cxn>
                <a:cxn ang="0">
                  <a:pos x="297" y="311"/>
                </a:cxn>
                <a:cxn ang="0">
                  <a:pos x="238" y="204"/>
                </a:cxn>
                <a:cxn ang="0">
                  <a:pos x="168" y="101"/>
                </a:cxn>
                <a:cxn ang="0">
                  <a:pos x="106" y="26"/>
                </a:cxn>
                <a:cxn ang="0">
                  <a:pos x="136" y="0"/>
                </a:cxn>
                <a:cxn ang="0">
                  <a:pos x="14" y="0"/>
                </a:cxn>
                <a:cxn ang="0">
                  <a:pos x="0" y="118"/>
                </a:cxn>
                <a:cxn ang="0">
                  <a:pos x="31" y="91"/>
                </a:cxn>
                <a:cxn ang="0">
                  <a:pos x="102" y="180"/>
                </a:cxn>
                <a:cxn ang="0">
                  <a:pos x="165" y="277"/>
                </a:cxn>
                <a:cxn ang="0">
                  <a:pos x="218" y="376"/>
                </a:cxn>
                <a:cxn ang="0">
                  <a:pos x="263" y="482"/>
                </a:cxn>
                <a:cxn ang="0">
                  <a:pos x="291" y="568"/>
                </a:cxn>
                <a:cxn ang="0">
                  <a:pos x="387" y="540"/>
                </a:cxn>
              </a:cxnLst>
              <a:rect l="0" t="0" r="r" b="b"/>
              <a:pathLst>
                <a:path w="387" h="568">
                  <a:moveTo>
                    <a:pt x="387" y="540"/>
                  </a:moveTo>
                  <a:lnTo>
                    <a:pt x="348" y="423"/>
                  </a:lnTo>
                  <a:lnTo>
                    <a:pt x="297" y="311"/>
                  </a:lnTo>
                  <a:lnTo>
                    <a:pt x="238" y="204"/>
                  </a:lnTo>
                  <a:lnTo>
                    <a:pt x="168" y="101"/>
                  </a:lnTo>
                  <a:lnTo>
                    <a:pt x="106" y="26"/>
                  </a:lnTo>
                  <a:lnTo>
                    <a:pt x="136" y="0"/>
                  </a:lnTo>
                  <a:lnTo>
                    <a:pt x="14" y="0"/>
                  </a:lnTo>
                  <a:lnTo>
                    <a:pt x="0" y="118"/>
                  </a:lnTo>
                  <a:lnTo>
                    <a:pt x="31" y="91"/>
                  </a:lnTo>
                  <a:lnTo>
                    <a:pt x="102" y="180"/>
                  </a:lnTo>
                  <a:lnTo>
                    <a:pt x="165" y="277"/>
                  </a:lnTo>
                  <a:lnTo>
                    <a:pt x="218" y="376"/>
                  </a:lnTo>
                  <a:lnTo>
                    <a:pt x="263" y="482"/>
                  </a:lnTo>
                  <a:lnTo>
                    <a:pt x="291" y="568"/>
                  </a:lnTo>
                  <a:lnTo>
                    <a:pt x="387" y="540"/>
                  </a:lnTo>
                  <a:close/>
                </a:path>
              </a:pathLst>
            </a:custGeom>
            <a:pattFill prst="ltUpDiag">
              <a:fgClr>
                <a:srgbClr val="000000"/>
              </a:fgClr>
              <a:bgClr>
                <a:srgbClr val="FFFFFF"/>
              </a:bgClr>
            </a:patt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99" name="Arc 79"/>
            <p:cNvSpPr>
              <a:spLocks/>
            </p:cNvSpPr>
            <p:nvPr/>
          </p:nvSpPr>
          <p:spPr bwMode="auto">
            <a:xfrm>
              <a:off x="2813" y="1229"/>
              <a:ext cx="1691" cy="1154"/>
            </a:xfrm>
            <a:custGeom>
              <a:avLst/>
              <a:gdLst>
                <a:gd name="G0" fmla="+- 0 0 0"/>
                <a:gd name="G1" fmla="+- 14144 0 0"/>
                <a:gd name="G2" fmla="+- 21600 0 0"/>
                <a:gd name="T0" fmla="*/ 16325 w 20729"/>
                <a:gd name="T1" fmla="*/ 0 h 14144"/>
                <a:gd name="T2" fmla="*/ 20729 w 20729"/>
                <a:gd name="T3" fmla="*/ 8071 h 14144"/>
                <a:gd name="T4" fmla="*/ 0 w 20729"/>
                <a:gd name="T5" fmla="*/ 14144 h 14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729" h="14144" fill="none" extrusionOk="0">
                  <a:moveTo>
                    <a:pt x="16325" y="-1"/>
                  </a:moveTo>
                  <a:cubicBezTo>
                    <a:pt x="18355" y="2343"/>
                    <a:pt x="19857" y="5095"/>
                    <a:pt x="20728" y="8071"/>
                  </a:cubicBezTo>
                </a:path>
                <a:path w="20729" h="14144" stroke="0" extrusionOk="0">
                  <a:moveTo>
                    <a:pt x="16325" y="-1"/>
                  </a:moveTo>
                  <a:cubicBezTo>
                    <a:pt x="18355" y="2343"/>
                    <a:pt x="19857" y="5095"/>
                    <a:pt x="20728" y="8071"/>
                  </a:cubicBezTo>
                  <a:lnTo>
                    <a:pt x="0" y="14144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0" name="Arc 80"/>
            <p:cNvSpPr>
              <a:spLocks/>
            </p:cNvSpPr>
            <p:nvPr/>
          </p:nvSpPr>
          <p:spPr bwMode="auto">
            <a:xfrm>
              <a:off x="2815" y="1311"/>
              <a:ext cx="1569" cy="1072"/>
            </a:xfrm>
            <a:custGeom>
              <a:avLst/>
              <a:gdLst>
                <a:gd name="G0" fmla="+- 0 0 0"/>
                <a:gd name="G1" fmla="+- 14161 0 0"/>
                <a:gd name="G2" fmla="+- 21600 0 0"/>
                <a:gd name="T0" fmla="*/ 16310 w 20725"/>
                <a:gd name="T1" fmla="*/ 0 h 14161"/>
                <a:gd name="T2" fmla="*/ 20725 w 20725"/>
                <a:gd name="T3" fmla="*/ 8075 h 14161"/>
                <a:gd name="T4" fmla="*/ 0 w 20725"/>
                <a:gd name="T5" fmla="*/ 14161 h 14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725" h="14161" fill="none" extrusionOk="0">
                  <a:moveTo>
                    <a:pt x="16310" y="-1"/>
                  </a:moveTo>
                  <a:cubicBezTo>
                    <a:pt x="18344" y="2343"/>
                    <a:pt x="19850" y="5097"/>
                    <a:pt x="20724" y="8075"/>
                  </a:cubicBezTo>
                </a:path>
                <a:path w="20725" h="14161" stroke="0" extrusionOk="0">
                  <a:moveTo>
                    <a:pt x="16310" y="-1"/>
                  </a:moveTo>
                  <a:cubicBezTo>
                    <a:pt x="18344" y="2343"/>
                    <a:pt x="19850" y="5097"/>
                    <a:pt x="20724" y="8075"/>
                  </a:cubicBezTo>
                  <a:lnTo>
                    <a:pt x="0" y="14161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1" name="Line 81"/>
            <p:cNvSpPr>
              <a:spLocks noChangeShapeType="1"/>
            </p:cNvSpPr>
            <p:nvPr/>
          </p:nvSpPr>
          <p:spPr bwMode="auto">
            <a:xfrm flipV="1">
              <a:off x="4381" y="1887"/>
              <a:ext cx="123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2" name="Freeform 82"/>
            <p:cNvSpPr>
              <a:spLocks/>
            </p:cNvSpPr>
            <p:nvPr/>
          </p:nvSpPr>
          <p:spPr bwMode="auto">
            <a:xfrm>
              <a:off x="4009" y="1196"/>
              <a:ext cx="174" cy="151"/>
            </a:xfrm>
            <a:custGeom>
              <a:avLst/>
              <a:gdLst/>
              <a:ahLst/>
              <a:cxnLst>
                <a:cxn ang="0">
                  <a:pos x="20" y="60"/>
                </a:cxn>
                <a:cxn ang="0">
                  <a:pos x="0" y="78"/>
                </a:cxn>
                <a:cxn ang="0">
                  <a:pos x="9" y="0"/>
                </a:cxn>
                <a:cxn ang="0">
                  <a:pos x="90" y="0"/>
                </a:cxn>
                <a:cxn ang="0">
                  <a:pos x="70" y="17"/>
                </a:cxn>
              </a:cxnLst>
              <a:rect l="0" t="0" r="r" b="b"/>
              <a:pathLst>
                <a:path w="90" h="78">
                  <a:moveTo>
                    <a:pt x="20" y="60"/>
                  </a:moveTo>
                  <a:lnTo>
                    <a:pt x="0" y="78"/>
                  </a:lnTo>
                  <a:lnTo>
                    <a:pt x="9" y="0"/>
                  </a:lnTo>
                  <a:lnTo>
                    <a:pt x="90" y="0"/>
                  </a:lnTo>
                  <a:lnTo>
                    <a:pt x="70" y="1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3" name="Line 83"/>
            <p:cNvSpPr>
              <a:spLocks noChangeShapeType="1"/>
            </p:cNvSpPr>
            <p:nvPr/>
          </p:nvSpPr>
          <p:spPr bwMode="auto">
            <a:xfrm flipH="1">
              <a:off x="4334" y="1492"/>
              <a:ext cx="294" cy="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4" name="Rectangle 84"/>
            <p:cNvSpPr>
              <a:spLocks noChangeArrowheads="1"/>
            </p:cNvSpPr>
            <p:nvPr/>
          </p:nvSpPr>
          <p:spPr bwMode="auto">
            <a:xfrm>
              <a:off x="4635" y="1370"/>
              <a:ext cx="436" cy="1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>
                  <a:solidFill>
                    <a:srgbClr val="000000"/>
                  </a:solidFill>
                </a:rPr>
                <a:t>CaMV35S</a:t>
              </a:r>
              <a:endParaRPr lang="en-US" altLang="zh-CN"/>
            </a:p>
          </p:txBody>
        </p:sp>
        <p:sp>
          <p:nvSpPr>
            <p:cNvPr id="5205" name="Freeform 85"/>
            <p:cNvSpPr>
              <a:spLocks/>
            </p:cNvSpPr>
            <p:nvPr/>
          </p:nvSpPr>
          <p:spPr bwMode="auto">
            <a:xfrm>
              <a:off x="3092" y="618"/>
              <a:ext cx="981" cy="623"/>
            </a:xfrm>
            <a:custGeom>
              <a:avLst/>
              <a:gdLst/>
              <a:ahLst/>
              <a:cxnLst>
                <a:cxn ang="0">
                  <a:pos x="766" y="417"/>
                </a:cxn>
                <a:cxn ang="0">
                  <a:pos x="677" y="333"/>
                </a:cxn>
                <a:cxn ang="0">
                  <a:pos x="579" y="257"/>
                </a:cxn>
                <a:cxn ang="0">
                  <a:pos x="476" y="191"/>
                </a:cxn>
                <a:cxn ang="0">
                  <a:pos x="367" y="133"/>
                </a:cxn>
                <a:cxn ang="0">
                  <a:pos x="254" y="86"/>
                </a:cxn>
                <a:cxn ang="0">
                  <a:pos x="136" y="49"/>
                </a:cxn>
                <a:cxn ang="0">
                  <a:pos x="89" y="38"/>
                </a:cxn>
                <a:cxn ang="0">
                  <a:pos x="98" y="0"/>
                </a:cxn>
                <a:cxn ang="0">
                  <a:pos x="0" y="71"/>
                </a:cxn>
                <a:cxn ang="0">
                  <a:pos x="59" y="174"/>
                </a:cxn>
                <a:cxn ang="0">
                  <a:pos x="66" y="135"/>
                </a:cxn>
                <a:cxn ang="0">
                  <a:pos x="177" y="165"/>
                </a:cxn>
                <a:cxn ang="0">
                  <a:pos x="284" y="206"/>
                </a:cxn>
                <a:cxn ang="0">
                  <a:pos x="387" y="254"/>
                </a:cxn>
                <a:cxn ang="0">
                  <a:pos x="485" y="313"/>
                </a:cxn>
                <a:cxn ang="0">
                  <a:pos x="577" y="380"/>
                </a:cxn>
                <a:cxn ang="0">
                  <a:pos x="663" y="455"/>
                </a:cxn>
                <a:cxn ang="0">
                  <a:pos x="695" y="487"/>
                </a:cxn>
                <a:cxn ang="0">
                  <a:pos x="766" y="417"/>
                </a:cxn>
              </a:cxnLst>
              <a:rect l="0" t="0" r="r" b="b"/>
              <a:pathLst>
                <a:path w="766" h="487">
                  <a:moveTo>
                    <a:pt x="766" y="417"/>
                  </a:moveTo>
                  <a:lnTo>
                    <a:pt x="677" y="333"/>
                  </a:lnTo>
                  <a:lnTo>
                    <a:pt x="579" y="257"/>
                  </a:lnTo>
                  <a:lnTo>
                    <a:pt x="476" y="191"/>
                  </a:lnTo>
                  <a:lnTo>
                    <a:pt x="367" y="133"/>
                  </a:lnTo>
                  <a:lnTo>
                    <a:pt x="254" y="86"/>
                  </a:lnTo>
                  <a:lnTo>
                    <a:pt x="136" y="49"/>
                  </a:lnTo>
                  <a:lnTo>
                    <a:pt x="89" y="38"/>
                  </a:lnTo>
                  <a:lnTo>
                    <a:pt x="98" y="0"/>
                  </a:lnTo>
                  <a:lnTo>
                    <a:pt x="0" y="71"/>
                  </a:lnTo>
                  <a:lnTo>
                    <a:pt x="59" y="174"/>
                  </a:lnTo>
                  <a:lnTo>
                    <a:pt x="66" y="135"/>
                  </a:lnTo>
                  <a:lnTo>
                    <a:pt x="177" y="165"/>
                  </a:lnTo>
                  <a:lnTo>
                    <a:pt x="284" y="206"/>
                  </a:lnTo>
                  <a:lnTo>
                    <a:pt x="387" y="254"/>
                  </a:lnTo>
                  <a:lnTo>
                    <a:pt x="485" y="313"/>
                  </a:lnTo>
                  <a:lnTo>
                    <a:pt x="577" y="380"/>
                  </a:lnTo>
                  <a:lnTo>
                    <a:pt x="663" y="455"/>
                  </a:lnTo>
                  <a:lnTo>
                    <a:pt x="695" y="487"/>
                  </a:lnTo>
                  <a:lnTo>
                    <a:pt x="766" y="417"/>
                  </a:lnTo>
                  <a:close/>
                </a:path>
              </a:pathLst>
            </a:custGeom>
            <a:pattFill prst="ltUpDiag">
              <a:fgClr>
                <a:srgbClr val="000000"/>
              </a:fgClr>
              <a:bgClr>
                <a:srgbClr val="FFFFFF"/>
              </a:bgClr>
            </a:patt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6" name="Arc 86"/>
            <p:cNvSpPr>
              <a:spLocks/>
            </p:cNvSpPr>
            <p:nvPr/>
          </p:nvSpPr>
          <p:spPr bwMode="auto">
            <a:xfrm>
              <a:off x="2813" y="666"/>
              <a:ext cx="1260" cy="1717"/>
            </a:xfrm>
            <a:custGeom>
              <a:avLst/>
              <a:gdLst>
                <a:gd name="G0" fmla="+- 0 0 0"/>
                <a:gd name="G1" fmla="+- 21055 0 0"/>
                <a:gd name="G2" fmla="+- 21600 0 0"/>
                <a:gd name="T0" fmla="*/ 4820 w 15445"/>
                <a:gd name="T1" fmla="*/ 0 h 21055"/>
                <a:gd name="T2" fmla="*/ 15445 w 15445"/>
                <a:gd name="T3" fmla="*/ 5955 h 21055"/>
                <a:gd name="T4" fmla="*/ 0 w 15445"/>
                <a:gd name="T5" fmla="*/ 21055 h 210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45" h="21055" fill="none" extrusionOk="0">
                  <a:moveTo>
                    <a:pt x="4820" y="-1"/>
                  </a:moveTo>
                  <a:cubicBezTo>
                    <a:pt x="8859" y="924"/>
                    <a:pt x="12547" y="2991"/>
                    <a:pt x="15445" y="5954"/>
                  </a:cubicBezTo>
                </a:path>
                <a:path w="15445" h="21055" stroke="0" extrusionOk="0">
                  <a:moveTo>
                    <a:pt x="4820" y="-1"/>
                  </a:moveTo>
                  <a:cubicBezTo>
                    <a:pt x="8859" y="924"/>
                    <a:pt x="12547" y="2991"/>
                    <a:pt x="15445" y="5954"/>
                  </a:cubicBezTo>
                  <a:lnTo>
                    <a:pt x="0" y="21055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7" name="Arc 87"/>
            <p:cNvSpPr>
              <a:spLocks/>
            </p:cNvSpPr>
            <p:nvPr/>
          </p:nvSpPr>
          <p:spPr bwMode="auto">
            <a:xfrm>
              <a:off x="2815" y="790"/>
              <a:ext cx="1168" cy="1593"/>
            </a:xfrm>
            <a:custGeom>
              <a:avLst/>
              <a:gdLst>
                <a:gd name="G0" fmla="+- 0 0 0"/>
                <a:gd name="G1" fmla="+- 21063 0 0"/>
                <a:gd name="G2" fmla="+- 21600 0 0"/>
                <a:gd name="T0" fmla="*/ 4786 w 15433"/>
                <a:gd name="T1" fmla="*/ 0 h 21063"/>
                <a:gd name="T2" fmla="*/ 15433 w 15433"/>
                <a:gd name="T3" fmla="*/ 5951 h 21063"/>
                <a:gd name="T4" fmla="*/ 0 w 15433"/>
                <a:gd name="T5" fmla="*/ 21063 h 210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33" h="21063" fill="none" extrusionOk="0">
                  <a:moveTo>
                    <a:pt x="4786" y="-1"/>
                  </a:moveTo>
                  <a:cubicBezTo>
                    <a:pt x="8833" y="919"/>
                    <a:pt x="12529" y="2985"/>
                    <a:pt x="15433" y="5950"/>
                  </a:cubicBezTo>
                </a:path>
                <a:path w="15433" h="21063" stroke="0" extrusionOk="0">
                  <a:moveTo>
                    <a:pt x="4786" y="-1"/>
                  </a:moveTo>
                  <a:cubicBezTo>
                    <a:pt x="8833" y="919"/>
                    <a:pt x="12529" y="2985"/>
                    <a:pt x="15433" y="5950"/>
                  </a:cubicBezTo>
                  <a:lnTo>
                    <a:pt x="0" y="21063"/>
                  </a:lnTo>
                  <a:close/>
                </a:path>
              </a:pathLst>
            </a:cu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8" name="Line 88"/>
            <p:cNvSpPr>
              <a:spLocks noChangeShapeType="1"/>
            </p:cNvSpPr>
            <p:nvPr/>
          </p:nvSpPr>
          <p:spPr bwMode="auto">
            <a:xfrm flipV="1">
              <a:off x="3982" y="1151"/>
              <a:ext cx="91" cy="9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09" name="Freeform 89"/>
            <p:cNvSpPr>
              <a:spLocks/>
            </p:cNvSpPr>
            <p:nvPr/>
          </p:nvSpPr>
          <p:spPr bwMode="auto">
            <a:xfrm>
              <a:off x="3092" y="618"/>
              <a:ext cx="126" cy="222"/>
            </a:xfrm>
            <a:custGeom>
              <a:avLst/>
              <a:gdLst/>
              <a:ahLst/>
              <a:cxnLst>
                <a:cxn ang="0">
                  <a:pos x="44" y="89"/>
                </a:cxn>
                <a:cxn ang="0">
                  <a:pos x="39" y="115"/>
                </a:cxn>
                <a:cxn ang="0">
                  <a:pos x="0" y="47"/>
                </a:cxn>
                <a:cxn ang="0">
                  <a:pos x="65" y="0"/>
                </a:cxn>
                <a:cxn ang="0">
                  <a:pos x="59" y="25"/>
                </a:cxn>
              </a:cxnLst>
              <a:rect l="0" t="0" r="r" b="b"/>
              <a:pathLst>
                <a:path w="65" h="115">
                  <a:moveTo>
                    <a:pt x="44" y="89"/>
                  </a:moveTo>
                  <a:lnTo>
                    <a:pt x="39" y="115"/>
                  </a:lnTo>
                  <a:lnTo>
                    <a:pt x="0" y="47"/>
                  </a:lnTo>
                  <a:lnTo>
                    <a:pt x="65" y="0"/>
                  </a:lnTo>
                  <a:lnTo>
                    <a:pt x="59" y="2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10" name="Line 90"/>
            <p:cNvSpPr>
              <a:spLocks noChangeShapeType="1"/>
            </p:cNvSpPr>
            <p:nvPr/>
          </p:nvSpPr>
          <p:spPr bwMode="auto">
            <a:xfrm flipH="1">
              <a:off x="3629" y="813"/>
              <a:ext cx="454" cy="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11" name="Rectangle 91"/>
            <p:cNvSpPr>
              <a:spLocks noChangeArrowheads="1"/>
            </p:cNvSpPr>
            <p:nvPr/>
          </p:nvSpPr>
          <p:spPr bwMode="auto">
            <a:xfrm>
              <a:off x="4088" y="692"/>
              <a:ext cx="283" cy="1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>
                  <a:solidFill>
                    <a:srgbClr val="000000"/>
                  </a:solidFill>
                </a:rPr>
                <a:t>CfJMT</a:t>
              </a:r>
              <a:endParaRPr lang="en-US" altLang="zh-CN"/>
            </a:p>
          </p:txBody>
        </p:sp>
        <p:sp>
          <p:nvSpPr>
            <p:cNvPr id="5212" name="Line 92"/>
            <p:cNvSpPr>
              <a:spLocks noChangeShapeType="1"/>
            </p:cNvSpPr>
            <p:nvPr/>
          </p:nvSpPr>
          <p:spPr bwMode="auto">
            <a:xfrm flipH="1">
              <a:off x="2829" y="565"/>
              <a:ext cx="2" cy="24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13" name="Line 93"/>
            <p:cNvSpPr>
              <a:spLocks noChangeShapeType="1"/>
            </p:cNvSpPr>
            <p:nvPr/>
          </p:nvSpPr>
          <p:spPr bwMode="auto">
            <a:xfrm flipH="1">
              <a:off x="2831" y="257"/>
              <a:ext cx="164" cy="308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14" name="Rectangle 94"/>
            <p:cNvSpPr>
              <a:spLocks noChangeArrowheads="1"/>
            </p:cNvSpPr>
            <p:nvPr/>
          </p:nvSpPr>
          <p:spPr bwMode="auto">
            <a:xfrm>
              <a:off x="2999" y="161"/>
              <a:ext cx="304" cy="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EcoRI (1)</a:t>
              </a:r>
              <a:endParaRPr lang="en-US" altLang="zh-CN"/>
            </a:p>
          </p:txBody>
        </p:sp>
        <p:sp>
          <p:nvSpPr>
            <p:cNvPr id="5215" name="Line 95"/>
            <p:cNvSpPr>
              <a:spLocks noChangeShapeType="1"/>
            </p:cNvSpPr>
            <p:nvPr/>
          </p:nvSpPr>
          <p:spPr bwMode="auto">
            <a:xfrm flipH="1">
              <a:off x="4219" y="1558"/>
              <a:ext cx="213" cy="10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16" name="Line 96"/>
            <p:cNvSpPr>
              <a:spLocks noChangeShapeType="1"/>
            </p:cNvSpPr>
            <p:nvPr/>
          </p:nvSpPr>
          <p:spPr bwMode="auto">
            <a:xfrm flipH="1">
              <a:off x="4432" y="1521"/>
              <a:ext cx="260" cy="37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17" name="Rectangle 97"/>
            <p:cNvSpPr>
              <a:spLocks noChangeArrowheads="1"/>
            </p:cNvSpPr>
            <p:nvPr/>
          </p:nvSpPr>
          <p:spPr bwMode="auto">
            <a:xfrm>
              <a:off x="4696" y="1517"/>
              <a:ext cx="37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NcoI (1941)</a:t>
              </a:r>
              <a:endParaRPr lang="en-US" altLang="zh-CN"/>
            </a:p>
          </p:txBody>
        </p:sp>
        <p:sp>
          <p:nvSpPr>
            <p:cNvPr id="5218" name="Line 98"/>
            <p:cNvSpPr>
              <a:spLocks noChangeShapeType="1"/>
            </p:cNvSpPr>
            <p:nvPr/>
          </p:nvSpPr>
          <p:spPr bwMode="auto">
            <a:xfrm flipH="1">
              <a:off x="4322" y="1859"/>
              <a:ext cx="233" cy="7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19" name="Line 99"/>
            <p:cNvSpPr>
              <a:spLocks noChangeShapeType="1"/>
            </p:cNvSpPr>
            <p:nvPr/>
          </p:nvSpPr>
          <p:spPr bwMode="auto">
            <a:xfrm flipH="1" flipV="1">
              <a:off x="4555" y="1859"/>
              <a:ext cx="220" cy="28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20" name="Rectangle 100"/>
            <p:cNvSpPr>
              <a:spLocks noChangeArrowheads="1"/>
            </p:cNvSpPr>
            <p:nvPr/>
          </p:nvSpPr>
          <p:spPr bwMode="auto">
            <a:xfrm>
              <a:off x="4779" y="1791"/>
              <a:ext cx="35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PstI (2260)</a:t>
              </a:r>
              <a:endParaRPr lang="en-US" altLang="zh-CN"/>
            </a:p>
          </p:txBody>
        </p:sp>
        <p:sp>
          <p:nvSpPr>
            <p:cNvPr id="5221" name="Line 101"/>
            <p:cNvSpPr>
              <a:spLocks noChangeShapeType="1"/>
            </p:cNvSpPr>
            <p:nvPr/>
          </p:nvSpPr>
          <p:spPr bwMode="auto">
            <a:xfrm flipH="1">
              <a:off x="3071" y="589"/>
              <a:ext cx="40" cy="24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22" name="Line 102"/>
            <p:cNvSpPr>
              <a:spLocks noChangeShapeType="1"/>
            </p:cNvSpPr>
            <p:nvPr/>
          </p:nvSpPr>
          <p:spPr bwMode="auto">
            <a:xfrm flipH="1">
              <a:off x="3111" y="529"/>
              <a:ext cx="470" cy="60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23" name="Rectangle 103"/>
            <p:cNvSpPr>
              <a:spLocks noChangeArrowheads="1"/>
            </p:cNvSpPr>
            <p:nvPr/>
          </p:nvSpPr>
          <p:spPr bwMode="auto">
            <a:xfrm>
              <a:off x="3585" y="433"/>
              <a:ext cx="332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SacI (276)</a:t>
              </a:r>
              <a:endParaRPr lang="en-US" altLang="zh-CN"/>
            </a:p>
          </p:txBody>
        </p:sp>
        <p:sp>
          <p:nvSpPr>
            <p:cNvPr id="5224" name="Line 104"/>
            <p:cNvSpPr>
              <a:spLocks noChangeShapeType="1"/>
            </p:cNvSpPr>
            <p:nvPr/>
          </p:nvSpPr>
          <p:spPr bwMode="auto">
            <a:xfrm flipH="1">
              <a:off x="3941" y="1113"/>
              <a:ext cx="173" cy="16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25" name="Line 105"/>
            <p:cNvSpPr>
              <a:spLocks noChangeShapeType="1"/>
            </p:cNvSpPr>
            <p:nvPr/>
          </p:nvSpPr>
          <p:spPr bwMode="auto">
            <a:xfrm flipH="1">
              <a:off x="4114" y="1072"/>
              <a:ext cx="265" cy="41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26" name="Rectangle 106"/>
            <p:cNvSpPr>
              <a:spLocks noChangeArrowheads="1"/>
            </p:cNvSpPr>
            <p:nvPr/>
          </p:nvSpPr>
          <p:spPr bwMode="auto">
            <a:xfrm>
              <a:off x="4382" y="976"/>
              <a:ext cx="375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XbaI (1403)</a:t>
              </a:r>
              <a:endParaRPr lang="en-US" altLang="zh-CN"/>
            </a:p>
          </p:txBody>
        </p:sp>
        <p:sp>
          <p:nvSpPr>
            <p:cNvPr id="5227" name="Line 107"/>
            <p:cNvSpPr>
              <a:spLocks noChangeShapeType="1"/>
            </p:cNvSpPr>
            <p:nvPr/>
          </p:nvSpPr>
          <p:spPr bwMode="auto">
            <a:xfrm flipH="1">
              <a:off x="3422" y="707"/>
              <a:ext cx="95" cy="22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28" name="Line 108"/>
            <p:cNvSpPr>
              <a:spLocks noChangeShapeType="1"/>
            </p:cNvSpPr>
            <p:nvPr/>
          </p:nvSpPr>
          <p:spPr bwMode="auto">
            <a:xfrm flipH="1">
              <a:off x="3517" y="664"/>
              <a:ext cx="382" cy="43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29" name="Rectangle 109"/>
            <p:cNvSpPr>
              <a:spLocks noChangeArrowheads="1"/>
            </p:cNvSpPr>
            <p:nvPr/>
          </p:nvSpPr>
          <p:spPr bwMode="auto">
            <a:xfrm>
              <a:off x="3902" y="568"/>
              <a:ext cx="396" cy="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HindIII (691)</a:t>
              </a:r>
              <a:endParaRPr lang="en-US" altLang="zh-CN"/>
            </a:p>
          </p:txBody>
        </p:sp>
        <p:sp>
          <p:nvSpPr>
            <p:cNvPr id="5230" name="Line 110"/>
            <p:cNvSpPr>
              <a:spLocks noChangeShapeType="1"/>
            </p:cNvSpPr>
            <p:nvPr/>
          </p:nvSpPr>
          <p:spPr bwMode="auto">
            <a:xfrm flipH="1">
              <a:off x="4325" y="1867"/>
              <a:ext cx="231" cy="6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31" name="Line 111"/>
            <p:cNvSpPr>
              <a:spLocks noChangeShapeType="1"/>
            </p:cNvSpPr>
            <p:nvPr/>
          </p:nvSpPr>
          <p:spPr bwMode="auto">
            <a:xfrm flipH="1" flipV="1">
              <a:off x="4556" y="1867"/>
              <a:ext cx="258" cy="63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32" name="Rectangle 112"/>
            <p:cNvSpPr>
              <a:spLocks noChangeArrowheads="1"/>
            </p:cNvSpPr>
            <p:nvPr/>
          </p:nvSpPr>
          <p:spPr bwMode="auto">
            <a:xfrm>
              <a:off x="4818" y="1926"/>
              <a:ext cx="43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HindIII (2268)</a:t>
              </a:r>
              <a:endParaRPr lang="en-US" altLang="zh-CN"/>
            </a:p>
          </p:txBody>
        </p:sp>
        <p:sp>
          <p:nvSpPr>
            <p:cNvPr id="5233" name="Line 113"/>
            <p:cNvSpPr>
              <a:spLocks noChangeShapeType="1"/>
            </p:cNvSpPr>
            <p:nvPr/>
          </p:nvSpPr>
          <p:spPr bwMode="auto">
            <a:xfrm>
              <a:off x="1123" y="1711"/>
              <a:ext cx="226" cy="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34" name="Line 114"/>
            <p:cNvSpPr>
              <a:spLocks noChangeShapeType="1"/>
            </p:cNvSpPr>
            <p:nvPr/>
          </p:nvSpPr>
          <p:spPr bwMode="auto">
            <a:xfrm flipV="1">
              <a:off x="890" y="1711"/>
              <a:ext cx="233" cy="41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35" name="Rectangle 115"/>
            <p:cNvSpPr>
              <a:spLocks noChangeArrowheads="1"/>
            </p:cNvSpPr>
            <p:nvPr/>
          </p:nvSpPr>
          <p:spPr bwMode="auto">
            <a:xfrm>
              <a:off x="503" y="1656"/>
              <a:ext cx="376" cy="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XhoI (9051)</a:t>
              </a:r>
              <a:endParaRPr lang="en-US" altLang="zh-CN"/>
            </a:p>
          </p:txBody>
        </p:sp>
        <p:sp>
          <p:nvSpPr>
            <p:cNvPr id="5236" name="Line 116"/>
            <p:cNvSpPr>
              <a:spLocks noChangeShapeType="1"/>
            </p:cNvSpPr>
            <p:nvPr/>
          </p:nvSpPr>
          <p:spPr bwMode="auto">
            <a:xfrm>
              <a:off x="1819" y="860"/>
              <a:ext cx="133" cy="20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37" name="Line 117"/>
            <p:cNvSpPr>
              <a:spLocks noChangeShapeType="1"/>
            </p:cNvSpPr>
            <p:nvPr/>
          </p:nvSpPr>
          <p:spPr bwMode="auto">
            <a:xfrm>
              <a:off x="1531" y="799"/>
              <a:ext cx="288" cy="61"/>
            </a:xfrm>
            <a:prstGeom prst="line">
              <a:avLst/>
            </a:prstGeom>
            <a:noFill/>
            <a:ln w="0">
              <a:solidFill>
                <a:srgbClr val="40C08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38" name="Rectangle 118"/>
            <p:cNvSpPr>
              <a:spLocks noChangeArrowheads="1"/>
            </p:cNvSpPr>
            <p:nvPr/>
          </p:nvSpPr>
          <p:spPr bwMode="auto">
            <a:xfrm>
              <a:off x="1105" y="703"/>
              <a:ext cx="416" cy="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900">
                  <a:solidFill>
                    <a:srgbClr val="000000"/>
                  </a:solidFill>
                </a:rPr>
                <a:t>XhoI (10145)</a:t>
              </a:r>
              <a:endParaRPr lang="en-US" altLang="zh-CN"/>
            </a:p>
          </p:txBody>
        </p:sp>
      </p:grpSp>
      <p:sp>
        <p:nvSpPr>
          <p:cNvPr id="60" name="内容占位符 2"/>
          <p:cNvSpPr txBox="1">
            <a:spLocks/>
          </p:cNvSpPr>
          <p:nvPr/>
        </p:nvSpPr>
        <p:spPr>
          <a:xfrm>
            <a:off x="0" y="0"/>
            <a:ext cx="3357554" cy="4714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342900" lvl="0" indent="-342900">
              <a:spcBef>
                <a:spcPct val="20000"/>
              </a:spcBef>
              <a:defRPr/>
            </a:pPr>
            <a:r>
              <a:rPr lang="en-US" altLang="zh-CN" dirty="0" smtClean="0"/>
              <a:t>Figure S7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8"/>
          <p:cNvGrpSpPr>
            <a:grpSpLocks/>
          </p:cNvGrpSpPr>
          <p:nvPr/>
        </p:nvGrpSpPr>
        <p:grpSpPr bwMode="auto">
          <a:xfrm>
            <a:off x="1857356" y="1214422"/>
            <a:ext cx="4102119" cy="4010044"/>
            <a:chOff x="1584" y="825"/>
            <a:chExt cx="2170" cy="2151"/>
          </a:xfrm>
        </p:grpSpPr>
        <p:pic>
          <p:nvPicPr>
            <p:cNvPr id="5" name="Picture 5" descr="图片1"/>
            <p:cNvPicPr>
              <a:picLocks noChangeAspect="1" noChangeArrowheads="1"/>
            </p:cNvPicPr>
            <p:nvPr/>
          </p:nvPicPr>
          <p:blipFill>
            <a:blip r:embed="rId2" cstate="print">
              <a:lum bright="-24000"/>
            </a:blip>
            <a:srcRect l="48273" t="9413" r="19606" b="46796"/>
            <a:stretch>
              <a:fillRect/>
            </a:stretch>
          </p:blipFill>
          <p:spPr bwMode="auto">
            <a:xfrm>
              <a:off x="1920" y="1008"/>
              <a:ext cx="1776" cy="1968"/>
            </a:xfrm>
            <a:prstGeom prst="rect">
              <a:avLst/>
            </a:prstGeom>
            <a:noFill/>
          </p:spPr>
        </p:pic>
        <p:sp>
          <p:nvSpPr>
            <p:cNvPr id="6" name="Text Box 6"/>
            <p:cNvSpPr txBox="1">
              <a:spLocks noChangeArrowheads="1"/>
            </p:cNvSpPr>
            <p:nvPr/>
          </p:nvSpPr>
          <p:spPr bwMode="auto">
            <a:xfrm>
              <a:off x="1680" y="825"/>
              <a:ext cx="2074" cy="1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en-US" altLang="zh-CN" dirty="0"/>
                <a:t>kb     M     1      2      3      4      5     6     7</a:t>
              </a:r>
            </a:p>
          </p:txBody>
        </p: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1584" y="1956"/>
              <a:ext cx="364" cy="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r"/>
              <a:r>
                <a:rPr lang="en-US" altLang="zh-CN" sz="1400" dirty="0"/>
                <a:t>2</a:t>
              </a:r>
            </a:p>
            <a:p>
              <a:pPr algn="r"/>
              <a:endParaRPr lang="en-US" altLang="zh-CN" sz="1400" dirty="0"/>
            </a:p>
            <a:p>
              <a:pPr algn="r">
                <a:lnSpc>
                  <a:spcPts val="1800"/>
                </a:lnSpc>
              </a:pPr>
              <a:r>
                <a:rPr lang="en-US" altLang="zh-CN" sz="1400" dirty="0"/>
                <a:t>1</a:t>
              </a:r>
            </a:p>
            <a:p>
              <a:pPr algn="r">
                <a:lnSpc>
                  <a:spcPts val="1800"/>
                </a:lnSpc>
              </a:pPr>
              <a:r>
                <a:rPr lang="en-US" altLang="zh-CN" sz="1400" dirty="0"/>
                <a:t>0.75</a:t>
              </a:r>
            </a:p>
            <a:p>
              <a:pPr algn="r">
                <a:lnSpc>
                  <a:spcPts val="1800"/>
                </a:lnSpc>
              </a:pPr>
              <a:r>
                <a:rPr lang="en-US" altLang="zh-CN" sz="1400" dirty="0"/>
                <a:t>0.5</a:t>
              </a:r>
            </a:p>
            <a:p>
              <a:pPr algn="r">
                <a:lnSpc>
                  <a:spcPts val="1800"/>
                </a:lnSpc>
              </a:pPr>
              <a:r>
                <a:rPr lang="en-US" altLang="zh-CN" sz="1400" dirty="0"/>
                <a:t>0.25</a:t>
              </a:r>
            </a:p>
            <a:p>
              <a:pPr algn="r">
                <a:lnSpc>
                  <a:spcPts val="1800"/>
                </a:lnSpc>
              </a:pPr>
              <a:r>
                <a:rPr lang="en-US" altLang="zh-CN" sz="1400" dirty="0"/>
                <a:t>0.1</a:t>
              </a:r>
            </a:p>
          </p:txBody>
        </p:sp>
      </p:grpSp>
      <p:sp>
        <p:nvSpPr>
          <p:cNvPr id="10" name="内容占位符 2"/>
          <p:cNvSpPr txBox="1">
            <a:spLocks/>
          </p:cNvSpPr>
          <p:nvPr/>
        </p:nvSpPr>
        <p:spPr>
          <a:xfrm>
            <a:off x="0" y="0"/>
            <a:ext cx="3357554" cy="4714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342900" lvl="0" indent="-342900">
              <a:spcBef>
                <a:spcPct val="20000"/>
              </a:spcBef>
              <a:defRPr/>
            </a:pPr>
            <a:r>
              <a:rPr lang="en-US" altLang="zh-CN" smtClean="0"/>
              <a:t>Figure S8</a:t>
            </a:r>
            <a:endParaRPr kumimoji="0" lang="zh-CN" altLang="en-US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68</TotalTime>
  <Words>136</Words>
  <Application>Microsoft Office PowerPoint</Application>
  <PresentationFormat>On-screen Show (4:3)</PresentationFormat>
  <Paragraphs>69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主题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Joeyee</dc:creator>
  <cp:lastModifiedBy>AOMANGAY</cp:lastModifiedBy>
  <cp:revision>214</cp:revision>
  <dcterms:created xsi:type="dcterms:W3CDTF">2018-04-26T07:18:47Z</dcterms:created>
  <dcterms:modified xsi:type="dcterms:W3CDTF">2019-02-05T02:31:06Z</dcterms:modified>
</cp:coreProperties>
</file>